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67" r:id="rId1"/>
  </p:sldMasterIdLst>
  <p:notesMasterIdLst>
    <p:notesMasterId r:id="rId10"/>
  </p:notesMasterIdLst>
  <p:sldIdLst>
    <p:sldId id="1123" r:id="rId2"/>
    <p:sldId id="1125" r:id="rId3"/>
    <p:sldId id="1134" r:id="rId4"/>
    <p:sldId id="1135" r:id="rId5"/>
    <p:sldId id="1124" r:id="rId6"/>
    <p:sldId id="1126" r:id="rId7"/>
    <p:sldId id="1127" r:id="rId8"/>
    <p:sldId id="1132" r:id="rId9"/>
  </p:sldIdLst>
  <p:sldSz cx="12190413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66"/>
    <a:srgbClr val="F61B0A"/>
    <a:srgbClr val="38979E"/>
    <a:srgbClr val="00FFFF"/>
    <a:srgbClr val="E9EE12"/>
    <a:srgbClr val="617D7A"/>
    <a:srgbClr val="CC3300"/>
    <a:srgbClr val="A1E428"/>
    <a:srgbClr val="66CCFF"/>
    <a:srgbClr val="7C5A5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87" autoAdjust="0"/>
    <p:restoredTop sz="76650" autoAdjust="0"/>
  </p:normalViewPr>
  <p:slideViewPr>
    <p:cSldViewPr>
      <p:cViewPr>
        <p:scale>
          <a:sx n="42" d="100"/>
          <a:sy n="42" d="100"/>
        </p:scale>
        <p:origin x="1266" y="384"/>
      </p:cViewPr>
      <p:guideLst>
        <p:guide orient="horz" pos="2160"/>
        <p:guide pos="288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ar-E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4EED6480-ED8B-4BBE-A622-376BE9AE1365}" type="datetimeFigureOut">
              <a:rPr lang="ar-EG" smtClean="0"/>
              <a:pPr/>
              <a:t>19/08/1441</a:t>
            </a:fld>
            <a:endParaRPr lang="ar-E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2588" y="685800"/>
            <a:ext cx="60928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ar-E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3EAFE3B9-D881-4970-82DB-BE2F2212133B}" type="slidenum">
              <a:rPr lang="ar-EG" smtClean="0"/>
              <a:pPr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934610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AFE3B9-D881-4970-82DB-BE2F2212133B}" type="slidenum">
              <a:rPr lang="ar-EG" smtClean="0">
                <a:solidFill>
                  <a:prstClr val="black"/>
                </a:solidFill>
              </a:rPr>
              <a:pPr/>
              <a:t>2</a:t>
            </a:fld>
            <a:endParaRPr lang="ar-EG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98440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AFE3B9-D881-4970-82DB-BE2F2212133B}" type="slidenum">
              <a:rPr lang="ar-EG" smtClean="0">
                <a:solidFill>
                  <a:prstClr val="black"/>
                </a:solidFill>
              </a:rPr>
              <a:pPr/>
              <a:t>3</a:t>
            </a:fld>
            <a:endParaRPr lang="ar-EG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767729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AFE3B9-D881-4970-82DB-BE2F2212133B}" type="slidenum">
              <a:rPr lang="ar-EG" smtClean="0">
                <a:solidFill>
                  <a:prstClr val="black"/>
                </a:solidFill>
              </a:rPr>
              <a:pPr/>
              <a:t>4</a:t>
            </a:fld>
            <a:endParaRPr lang="ar-EG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0563278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AFE3B9-D881-4970-82DB-BE2F2212133B}" type="slidenum">
              <a:rPr lang="ar-EG" smtClean="0">
                <a:solidFill>
                  <a:prstClr val="black"/>
                </a:solidFill>
              </a:rPr>
              <a:pPr/>
              <a:t>6</a:t>
            </a:fld>
            <a:endParaRPr lang="ar-EG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984400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AFE3B9-D881-4970-82DB-BE2F2212133B}" type="slidenum">
              <a:rPr lang="ar-EG" smtClean="0">
                <a:solidFill>
                  <a:prstClr val="black"/>
                </a:solidFill>
              </a:rPr>
              <a:pPr/>
              <a:t>7</a:t>
            </a:fld>
            <a:endParaRPr lang="ar-EG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98440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805" y="1447800"/>
            <a:ext cx="8824509" cy="3329581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4805" y="4777380"/>
            <a:ext cx="8824509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650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anoramic 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6" y="4800587"/>
            <a:ext cx="8824508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54805" y="685800"/>
            <a:ext cx="8824509" cy="3640666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6" y="5367325"/>
            <a:ext cx="8824507" cy="493712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7402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4" y="1447800"/>
            <a:ext cx="8824510" cy="1981200"/>
          </a:xfrm>
        </p:spPr>
        <p:txBody>
          <a:bodyPr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4" y="3657600"/>
            <a:ext cx="8824510" cy="23622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1790731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596" y="1447800"/>
            <a:ext cx="7998274" cy="2323374"/>
          </a:xfrm>
        </p:spPr>
        <p:txBody>
          <a:bodyPr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1" name="Text Placeholder 3"/>
          <p:cNvSpPr>
            <a:spLocks noGrp="1"/>
          </p:cNvSpPr>
          <p:nvPr>
            <p:ph type="body" sz="half" idx="14"/>
          </p:nvPr>
        </p:nvSpPr>
        <p:spPr>
          <a:xfrm>
            <a:off x="1930149" y="3771174"/>
            <a:ext cx="7278701" cy="342174"/>
          </a:xfrm>
        </p:spPr>
        <p:txBody>
          <a:bodyPr vert="horz" lIns="91440" tIns="45720" rIns="91440" bIns="45720" rtlCol="0" anchor="t">
            <a:normAutofit/>
          </a:bodyPr>
          <a:lstStyle>
            <a:lvl1pPr marL="0" indent="0">
              <a:buNone/>
              <a:defRPr lang="en-US" sz="1400" b="0" i="0" kern="1200" cap="small" dirty="0">
                <a:solidFill>
                  <a:schemeClr val="bg2">
                    <a:lumMod val="40000"/>
                    <a:lumOff val="60000"/>
                  </a:schemeClr>
                </a:solidFill>
                <a:latin typeface="+mj-lt"/>
                <a:ea typeface="+mj-ea"/>
                <a:cs typeface="+mj-cs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marL="0" lvl="0" indent="0">
              <a:buNone/>
            </a:pPr>
            <a:r>
              <a:rPr lang="en-US"/>
              <a:t>Edit Master text styles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4" y="4350657"/>
            <a:ext cx="8824510" cy="16764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98178" y="971253"/>
            <a:ext cx="801808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bg2">
                    <a:lumMod val="40000"/>
                    <a:lumOff val="60000"/>
                  </a:schemeClr>
                </a:solidFill>
                <a:latin typeface="Arial"/>
                <a:ea typeface="+mj-ea"/>
                <a:cs typeface="+mj-cs"/>
              </a:defRPr>
            </a:lvl1pPr>
          </a:lstStyle>
          <a:p>
            <a:pPr defTabSz="457200"/>
            <a:r>
              <a:rPr lang="en-US" dirty="0">
                <a:solidFill>
                  <a:srgbClr val="1E5155">
                    <a:lumMod val="40000"/>
                    <a:lumOff val="60000"/>
                  </a:srgbClr>
                </a:solidFill>
              </a:rPr>
              <a:t>“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329275" y="2613787"/>
            <a:ext cx="801808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bg2">
                    <a:lumMod val="40000"/>
                    <a:lumOff val="60000"/>
                  </a:schemeClr>
                </a:solidFill>
                <a:latin typeface="Arial"/>
                <a:ea typeface="+mj-ea"/>
                <a:cs typeface="+mj-cs"/>
              </a:defRPr>
            </a:lvl1pPr>
          </a:lstStyle>
          <a:p>
            <a:pPr defTabSz="457200"/>
            <a:r>
              <a:rPr lang="en-US" dirty="0">
                <a:solidFill>
                  <a:srgbClr val="1E5155">
                    <a:lumMod val="40000"/>
                    <a:lumOff val="60000"/>
                  </a:srgbClr>
                </a:solidFill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330679579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4" y="3124201"/>
            <a:ext cx="8824511" cy="1653180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804" y="4777381"/>
            <a:ext cx="8824510" cy="860400"/>
          </a:xfrm>
        </p:spPr>
        <p:txBody>
          <a:bodyPr anchor="t"/>
          <a:lstStyle>
            <a:lvl1pPr marL="0" indent="0" algn="l">
              <a:buNone/>
              <a:defRPr sz="2000" cap="none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642189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2865" y="1981200"/>
            <a:ext cx="2946482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6" name="Text Placeholder 3"/>
          <p:cNvSpPr>
            <a:spLocks noGrp="1"/>
          </p:cNvSpPr>
          <p:nvPr>
            <p:ph type="body" sz="half" idx="15"/>
          </p:nvPr>
        </p:nvSpPr>
        <p:spPr>
          <a:xfrm>
            <a:off x="652378" y="2667000"/>
            <a:ext cx="2926969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83154" y="1981200"/>
            <a:ext cx="293585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9" name="Text Placeholder 3"/>
          <p:cNvSpPr>
            <a:spLocks noGrp="1"/>
          </p:cNvSpPr>
          <p:nvPr>
            <p:ph type="body" sz="half" idx="16"/>
          </p:nvPr>
        </p:nvSpPr>
        <p:spPr>
          <a:xfrm>
            <a:off x="3872602" y="2667000"/>
            <a:ext cx="2946410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123773" y="1981200"/>
            <a:ext cx="2931731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0" name="Text Placeholder 3"/>
          <p:cNvSpPr>
            <a:spLocks noGrp="1"/>
          </p:cNvSpPr>
          <p:nvPr>
            <p:ph type="body" sz="half" idx="17"/>
          </p:nvPr>
        </p:nvSpPr>
        <p:spPr>
          <a:xfrm>
            <a:off x="7123773" y="2667000"/>
            <a:ext cx="2931731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725657" y="2133600"/>
            <a:ext cx="0" cy="3962400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6961321" y="2133600"/>
            <a:ext cx="0" cy="3966882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63372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2378" y="4250949"/>
            <a:ext cx="293966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9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652378" y="2209800"/>
            <a:ext cx="2939667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2" name="Text Placeholder 3"/>
          <p:cNvSpPr>
            <a:spLocks noGrp="1"/>
          </p:cNvSpPr>
          <p:nvPr>
            <p:ph type="body" sz="half" idx="18"/>
          </p:nvPr>
        </p:nvSpPr>
        <p:spPr>
          <a:xfrm>
            <a:off x="652378" y="4827212"/>
            <a:ext cx="2939667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88869" y="4250949"/>
            <a:ext cx="2930144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0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3888868" y="2209800"/>
            <a:ext cx="2930144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3" name="Text Placeholder 3"/>
          <p:cNvSpPr>
            <a:spLocks noGrp="1"/>
          </p:cNvSpPr>
          <p:nvPr>
            <p:ph type="body" sz="half" idx="19"/>
          </p:nvPr>
        </p:nvSpPr>
        <p:spPr>
          <a:xfrm>
            <a:off x="3887516" y="4827211"/>
            <a:ext cx="2934024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123773" y="4250949"/>
            <a:ext cx="2931731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1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7123772" y="2209800"/>
            <a:ext cx="2931731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20"/>
          </p:nvPr>
        </p:nvSpPr>
        <p:spPr>
          <a:xfrm>
            <a:off x="7123648" y="4827209"/>
            <a:ext cx="2935615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cxnSp>
        <p:nvCxnSpPr>
          <p:cNvPr id="19" name="Straight Connector 18"/>
          <p:cNvCxnSpPr/>
          <p:nvPr/>
        </p:nvCxnSpPr>
        <p:spPr>
          <a:xfrm>
            <a:off x="3725657" y="2133600"/>
            <a:ext cx="0" cy="3962400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6961321" y="2133600"/>
            <a:ext cx="0" cy="3966882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6859858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 anchorCtr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9706382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303131" y="430213"/>
            <a:ext cx="1752373" cy="5826125"/>
          </a:xfrm>
        </p:spPr>
        <p:txBody>
          <a:bodyPr vert="eaVert" anchor="b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52378" y="887414"/>
            <a:ext cx="7422183" cy="536892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5753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4669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6" y="2861734"/>
            <a:ext cx="8824508" cy="1915647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805" y="4777381"/>
            <a:ext cx="8824509" cy="860400"/>
          </a:xfrm>
        </p:spPr>
        <p:txBody>
          <a:bodyPr anchor="t"/>
          <a:lstStyle>
            <a:lvl1pPr marL="0" indent="0" algn="l">
              <a:buNone/>
              <a:defRPr sz="2000" cap="all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39019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03169" y="2060576"/>
            <a:ext cx="4395767" cy="4195763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53757" y="2056092"/>
            <a:ext cx="4395769" cy="4200245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31423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3169" y="1905000"/>
            <a:ext cx="4395766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03169" y="2514600"/>
            <a:ext cx="4395767" cy="3741738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53759" y="1905000"/>
            <a:ext cx="439576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653759" y="2514600"/>
            <a:ext cx="4395767" cy="3741738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06206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3476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283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3" y="1447800"/>
            <a:ext cx="3400621" cy="1447800"/>
          </a:xfrm>
        </p:spPr>
        <p:txBody>
          <a:bodyPr anchor="b"/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83994" y="1447800"/>
            <a:ext cx="5195321" cy="4572000"/>
          </a:xfrm>
        </p:spPr>
        <p:txBody>
          <a:bodyPr anchor="ctr"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3" y="3129281"/>
            <a:ext cx="3400620" cy="289559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7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12857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3757" y="1854192"/>
            <a:ext cx="5092243" cy="1574808"/>
          </a:xfrm>
        </p:spPr>
        <p:txBody>
          <a:bodyPr anchor="b">
            <a:normAutofit/>
          </a:bodyPr>
          <a:lstStyle>
            <a:lvl1pPr algn="l">
              <a:defRPr sz="36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48642" y="1143000"/>
            <a:ext cx="3199983" cy="4572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4" y="3657600"/>
            <a:ext cx="5084317" cy="1371600"/>
          </a:xfrm>
        </p:spPr>
        <p:txBody>
          <a:bodyPr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36150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21" Type="http://schemas.openxmlformats.org/officeDocument/2006/relationships/image" Target="../media/image4.png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2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3"/>
          <a:stretch/>
        </p:blipFill>
        <p:spPr>
          <a:xfrm>
            <a:off x="0" y="2669686"/>
            <a:ext cx="4036487" cy="418831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40"/>
          <a:stretch/>
        </p:blipFill>
        <p:spPr>
          <a:xfrm>
            <a:off x="0" y="2892348"/>
            <a:ext cx="1522214" cy="2365453"/>
          </a:xfrm>
          <a:prstGeom prst="rect">
            <a:avLst/>
          </a:prstGeom>
        </p:spPr>
      </p:pic>
      <p:sp>
        <p:nvSpPr>
          <p:cNvPr id="16" name="Oval 15"/>
          <p:cNvSpPr/>
          <p:nvPr/>
        </p:nvSpPr>
        <p:spPr>
          <a:xfrm>
            <a:off x="8607891" y="1676400"/>
            <a:ext cx="2819033" cy="2819400"/>
          </a:xfrm>
          <a:prstGeom prst="ellipse">
            <a:avLst/>
          </a:prstGeom>
          <a:gradFill flip="none" rotWithShape="1">
            <a:gsLst>
              <a:gs pos="0">
                <a:schemeClr val="bg2">
                  <a:lumMod val="60000"/>
                  <a:lumOff val="40000"/>
                  <a:alpha val="7000"/>
                </a:schemeClr>
              </a:gs>
              <a:gs pos="69000">
                <a:schemeClr val="bg2">
                  <a:lumMod val="60000"/>
                  <a:lumOff val="40000"/>
                  <a:alpha val="0"/>
                </a:schemeClr>
              </a:gs>
              <a:gs pos="36000">
                <a:schemeClr val="bg2">
                  <a:lumMod val="60000"/>
                  <a:lumOff val="40000"/>
                  <a:alpha val="6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813"/>
          <a:stretch/>
        </p:blipFill>
        <p:spPr>
          <a:xfrm>
            <a:off x="7998371" y="0"/>
            <a:ext cx="1603178" cy="114140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320"/>
          <a:stretch/>
        </p:blipFill>
        <p:spPr>
          <a:xfrm>
            <a:off x="8604758" y="6096000"/>
            <a:ext cx="993605" cy="76200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10436453" y="0"/>
            <a:ext cx="685711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6027" y="452718"/>
            <a:ext cx="9403499" cy="140053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3169" y="2052919"/>
            <a:ext cx="8945376" cy="41954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 rot="5400000">
            <a:off x="10154253" y="1790721"/>
            <a:ext cx="990599" cy="304759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pPr defTabSz="457200"/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 defTabSz="457200"/>
              <a:t>4/12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 rot="5400000">
            <a:off x="8950157" y="3225318"/>
            <a:ext cx="3859795" cy="30476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pPr defTabSz="457200"/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gray">
          <a:xfrm>
            <a:off x="10351193" y="295730"/>
            <a:ext cx="838090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 defTabSz="457200"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613240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4368" r:id="rId1"/>
    <p:sldLayoutId id="2147484369" r:id="rId2"/>
    <p:sldLayoutId id="2147484370" r:id="rId3"/>
    <p:sldLayoutId id="2147484371" r:id="rId4"/>
    <p:sldLayoutId id="2147484372" r:id="rId5"/>
    <p:sldLayoutId id="2147484373" r:id="rId6"/>
    <p:sldLayoutId id="2147484374" r:id="rId7"/>
    <p:sldLayoutId id="2147484375" r:id="rId8"/>
    <p:sldLayoutId id="2147484376" r:id="rId9"/>
    <p:sldLayoutId id="2147484377" r:id="rId10"/>
    <p:sldLayoutId id="2147484378" r:id="rId11"/>
    <p:sldLayoutId id="2147484379" r:id="rId12"/>
    <p:sldLayoutId id="2147484380" r:id="rId13"/>
    <p:sldLayoutId id="2147484381" r:id="rId14"/>
    <p:sldLayoutId id="2147484382" r:id="rId15"/>
    <p:sldLayoutId id="2147484383" r:id="rId16"/>
    <p:sldLayoutId id="2147484384" r:id="rId17"/>
  </p:sldLayoutIdLst>
  <p:txStyles>
    <p:titleStyle>
      <a:lvl1pPr algn="l" defTabSz="457200" rtl="0" eaLnBrk="1" latinLnBrk="0" hangingPunct="1">
        <a:spcBef>
          <a:spcPct val="0"/>
        </a:spcBef>
        <a:buNone/>
        <a:defRPr sz="4200" b="0" i="0" kern="1200">
          <a:solidFill>
            <a:schemeClr val="tx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2000" b="0" i="0" kern="1200">
          <a:solidFill>
            <a:schemeClr val="tx1"/>
          </a:solidFill>
          <a:latin typeface="+mj-lt"/>
          <a:ea typeface="+mj-ea"/>
          <a:cs typeface="+mj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800" b="0" i="0" kern="1200">
          <a:solidFill>
            <a:schemeClr val="tx1"/>
          </a:solidFill>
          <a:latin typeface="+mj-lt"/>
          <a:ea typeface="+mj-ea"/>
          <a:cs typeface="+mj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600" b="0" i="0" kern="1200">
          <a:solidFill>
            <a:schemeClr val="tx1"/>
          </a:solidFill>
          <a:latin typeface="+mj-lt"/>
          <a:ea typeface="+mj-ea"/>
          <a:cs typeface="+mj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5pPr>
      <a:lvl6pPr marL="2506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7.png"/><Relationship Id="rId4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5" Type="http://schemas.openxmlformats.org/officeDocument/2006/relationships/image" Target="../media/image8.png"/><Relationship Id="rId4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5" Type="http://schemas.openxmlformats.org/officeDocument/2006/relationships/image" Target="../media/image9.png"/><Relationship Id="rId4" Type="http://schemas.openxmlformats.org/officeDocument/2006/relationships/notesSlide" Target="../notesSlides/notesSlide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g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055646" y="-69119"/>
            <a:ext cx="1998936" cy="814773"/>
            <a:chOff x="9479582" y="-116888"/>
            <a:chExt cx="2729881" cy="1048170"/>
          </a:xfrm>
        </p:grpSpPr>
        <p:sp>
          <p:nvSpPr>
            <p:cNvPr id="4" name="Rectangle 8"/>
            <p:cNvSpPr/>
            <p:nvPr/>
          </p:nvSpPr>
          <p:spPr>
            <a:xfrm rot="5400000" flipH="1">
              <a:off x="10370523" y="-950762"/>
              <a:ext cx="825382" cy="2607264"/>
            </a:xfrm>
            <a:custGeom>
              <a:avLst/>
              <a:gdLst>
                <a:gd name="connsiteX0" fmla="*/ 0 w 381000"/>
                <a:gd name="connsiteY0" fmla="*/ 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0 w 381000"/>
                <a:gd name="connsiteY4" fmla="*/ 0 h 1066800"/>
                <a:gd name="connsiteX0" fmla="*/ 155804 w 381000"/>
                <a:gd name="connsiteY0" fmla="*/ 77413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155804 w 381000"/>
                <a:gd name="connsiteY4" fmla="*/ 77413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2100"/>
                <a:gd name="connsiteY0" fmla="*/ 1066800 h 1266097"/>
                <a:gd name="connsiteX1" fmla="*/ 381000 w 382100"/>
                <a:gd name="connsiteY1" fmla="*/ 0 h 1266097"/>
                <a:gd name="connsiteX2" fmla="*/ 382100 w 382100"/>
                <a:gd name="connsiteY2" fmla="*/ 1266097 h 1266097"/>
                <a:gd name="connsiteX3" fmla="*/ 0 w 382100"/>
                <a:gd name="connsiteY3" fmla="*/ 1066800 h 1266097"/>
                <a:gd name="connsiteX0" fmla="*/ 81205 w 463305"/>
                <a:gd name="connsiteY0" fmla="*/ 1066800 h 1278547"/>
                <a:gd name="connsiteX1" fmla="*/ 462205 w 463305"/>
                <a:gd name="connsiteY1" fmla="*/ 0 h 1278547"/>
                <a:gd name="connsiteX2" fmla="*/ 463305 w 463305"/>
                <a:gd name="connsiteY2" fmla="*/ 1266097 h 1278547"/>
                <a:gd name="connsiteX3" fmla="*/ 81205 w 463305"/>
                <a:gd name="connsiteY3" fmla="*/ 1066800 h 1278547"/>
                <a:gd name="connsiteX0" fmla="*/ 1100 w 1100"/>
                <a:gd name="connsiteY0" fmla="*/ 1266097 h 1266097"/>
                <a:gd name="connsiteX1" fmla="*/ 0 w 1100"/>
                <a:gd name="connsiteY1" fmla="*/ 0 h 1266097"/>
                <a:gd name="connsiteX2" fmla="*/ 1100 w 1100"/>
                <a:gd name="connsiteY2" fmla="*/ 1266097 h 1266097"/>
                <a:gd name="connsiteX0" fmla="*/ 4504727 w 4504727"/>
                <a:gd name="connsiteY0" fmla="*/ 10000 h 10000"/>
                <a:gd name="connsiteX1" fmla="*/ 4494727 w 4504727"/>
                <a:gd name="connsiteY1" fmla="*/ 0 h 10000"/>
                <a:gd name="connsiteX2" fmla="*/ 4504727 w 4504727"/>
                <a:gd name="connsiteY2" fmla="*/ 10000 h 10000"/>
                <a:gd name="connsiteX0" fmla="*/ 4711554 w 4711554"/>
                <a:gd name="connsiteY0" fmla="*/ 10376 h 10376"/>
                <a:gd name="connsiteX1" fmla="*/ 3938749 w 4711554"/>
                <a:gd name="connsiteY1" fmla="*/ 0 h 10376"/>
                <a:gd name="connsiteX2" fmla="*/ 4711554 w 4711554"/>
                <a:gd name="connsiteY2" fmla="*/ 10376 h 10376"/>
                <a:gd name="connsiteX0" fmla="*/ 5453499 w 5453499"/>
                <a:gd name="connsiteY0" fmla="*/ 10376 h 10376"/>
                <a:gd name="connsiteX1" fmla="*/ 4680694 w 5453499"/>
                <a:gd name="connsiteY1" fmla="*/ 0 h 10376"/>
                <a:gd name="connsiteX2" fmla="*/ 5453499 w 5453499"/>
                <a:gd name="connsiteY2" fmla="*/ 10376 h 10376"/>
                <a:gd name="connsiteX0" fmla="*/ 5188217 w 5193990"/>
                <a:gd name="connsiteY0" fmla="*/ 10193 h 10193"/>
                <a:gd name="connsiteX1" fmla="*/ 5193988 w 5193990"/>
                <a:gd name="connsiteY1" fmla="*/ 0 h 10193"/>
                <a:gd name="connsiteX2" fmla="*/ 5188217 w 5193990"/>
                <a:gd name="connsiteY2" fmla="*/ 10193 h 10193"/>
                <a:gd name="connsiteX0" fmla="*/ 5198190 w 5203963"/>
                <a:gd name="connsiteY0" fmla="*/ 10265 h 10265"/>
                <a:gd name="connsiteX1" fmla="*/ 5203961 w 5203963"/>
                <a:gd name="connsiteY1" fmla="*/ 72 h 10265"/>
                <a:gd name="connsiteX2" fmla="*/ 5198190 w 5203963"/>
                <a:gd name="connsiteY2" fmla="*/ 10265 h 10265"/>
                <a:gd name="connsiteX0" fmla="*/ 3303499 w 3309272"/>
                <a:gd name="connsiteY0" fmla="*/ 10194 h 10194"/>
                <a:gd name="connsiteX1" fmla="*/ 3309270 w 3309272"/>
                <a:gd name="connsiteY1" fmla="*/ 1 h 10194"/>
                <a:gd name="connsiteX2" fmla="*/ 3303499 w 3309272"/>
                <a:gd name="connsiteY2" fmla="*/ 10194 h 10194"/>
                <a:gd name="connsiteX0" fmla="*/ 3375826 w 3381599"/>
                <a:gd name="connsiteY0" fmla="*/ 10193 h 10193"/>
                <a:gd name="connsiteX1" fmla="*/ 3381597 w 3381599"/>
                <a:gd name="connsiteY1" fmla="*/ 0 h 10193"/>
                <a:gd name="connsiteX2" fmla="*/ 3375826 w 3381599"/>
                <a:gd name="connsiteY2" fmla="*/ 10193 h 10193"/>
                <a:gd name="connsiteX0" fmla="*/ 3305544 w 3311317"/>
                <a:gd name="connsiteY0" fmla="*/ 10193 h 10193"/>
                <a:gd name="connsiteX1" fmla="*/ 3311315 w 3311317"/>
                <a:gd name="connsiteY1" fmla="*/ 0 h 10193"/>
                <a:gd name="connsiteX2" fmla="*/ 3305544 w 3311317"/>
                <a:gd name="connsiteY2" fmla="*/ 10193 h 10193"/>
                <a:gd name="connsiteX0" fmla="*/ 3358833 w 3358835"/>
                <a:gd name="connsiteY0" fmla="*/ 8987 h 8987"/>
                <a:gd name="connsiteX1" fmla="*/ 3232079 w 3358835"/>
                <a:gd name="connsiteY1" fmla="*/ 0 h 8987"/>
                <a:gd name="connsiteX2" fmla="*/ 3358833 w 3358835"/>
                <a:gd name="connsiteY2" fmla="*/ 8987 h 8987"/>
                <a:gd name="connsiteX0" fmla="*/ 6470 w 6470"/>
                <a:gd name="connsiteY0" fmla="*/ 10000 h 10000"/>
                <a:gd name="connsiteX1" fmla="*/ 6093 w 6470"/>
                <a:gd name="connsiteY1" fmla="*/ 0 h 10000"/>
                <a:gd name="connsiteX2" fmla="*/ 6470 w 6470"/>
                <a:gd name="connsiteY2" fmla="*/ 10000 h 10000"/>
                <a:gd name="connsiteX0" fmla="*/ 9802 w 9802"/>
                <a:gd name="connsiteY0" fmla="*/ 10000 h 10000"/>
                <a:gd name="connsiteX1" fmla="*/ 9219 w 9802"/>
                <a:gd name="connsiteY1" fmla="*/ 0 h 10000"/>
                <a:gd name="connsiteX2" fmla="*/ 9802 w 9802"/>
                <a:gd name="connsiteY2" fmla="*/ 10000 h 10000"/>
                <a:gd name="connsiteX0" fmla="*/ 9298 w 10018"/>
                <a:gd name="connsiteY0" fmla="*/ 10932 h 10932"/>
                <a:gd name="connsiteX1" fmla="*/ 9994 w 10018"/>
                <a:gd name="connsiteY1" fmla="*/ 0 h 10932"/>
                <a:gd name="connsiteX2" fmla="*/ 9298 w 10018"/>
                <a:gd name="connsiteY2" fmla="*/ 10932 h 10932"/>
                <a:gd name="connsiteX0" fmla="*/ 10017 w 10017"/>
                <a:gd name="connsiteY0" fmla="*/ 10384 h 10384"/>
                <a:gd name="connsiteX1" fmla="*/ 9391 w 10017"/>
                <a:gd name="connsiteY1" fmla="*/ 0 h 10384"/>
                <a:gd name="connsiteX2" fmla="*/ 10017 w 10017"/>
                <a:gd name="connsiteY2" fmla="*/ 10384 h 10384"/>
                <a:gd name="connsiteX0" fmla="*/ 4732 w 4732"/>
                <a:gd name="connsiteY0" fmla="*/ 10390 h 11041"/>
                <a:gd name="connsiteX1" fmla="*/ 4106 w 4732"/>
                <a:gd name="connsiteY1" fmla="*/ 6 h 11041"/>
                <a:gd name="connsiteX2" fmla="*/ 3 w 4732"/>
                <a:gd name="connsiteY2" fmla="*/ 8873 h 11041"/>
                <a:gd name="connsiteX3" fmla="*/ 4732 w 4732"/>
                <a:gd name="connsiteY3" fmla="*/ 10390 h 11041"/>
                <a:gd name="connsiteX0" fmla="*/ 5470 w 5470"/>
                <a:gd name="connsiteY0" fmla="*/ 9410 h 10025"/>
                <a:gd name="connsiteX1" fmla="*/ 4147 w 5470"/>
                <a:gd name="connsiteY1" fmla="*/ 5 h 10025"/>
                <a:gd name="connsiteX2" fmla="*/ 13 w 5470"/>
                <a:gd name="connsiteY2" fmla="*/ 8140 h 10025"/>
                <a:gd name="connsiteX3" fmla="*/ 5470 w 5470"/>
                <a:gd name="connsiteY3" fmla="*/ 9410 h 10025"/>
                <a:gd name="connsiteX0" fmla="*/ 10000 w 10000"/>
                <a:gd name="connsiteY0" fmla="*/ 9387 h 9696"/>
                <a:gd name="connsiteX1" fmla="*/ 7581 w 10000"/>
                <a:gd name="connsiteY1" fmla="*/ 5 h 9696"/>
                <a:gd name="connsiteX2" fmla="*/ 24 w 10000"/>
                <a:gd name="connsiteY2" fmla="*/ 8120 h 9696"/>
                <a:gd name="connsiteX3" fmla="*/ 10000 w 10000"/>
                <a:gd name="connsiteY3" fmla="*/ 9387 h 9696"/>
                <a:gd name="connsiteX0" fmla="*/ 65556 w 65556"/>
                <a:gd name="connsiteY0" fmla="*/ 9686 h 10004"/>
                <a:gd name="connsiteX1" fmla="*/ 63137 w 65556"/>
                <a:gd name="connsiteY1" fmla="*/ 10 h 10004"/>
                <a:gd name="connsiteX2" fmla="*/ 55580 w 65556"/>
                <a:gd name="connsiteY2" fmla="*/ 8380 h 10004"/>
                <a:gd name="connsiteX3" fmla="*/ 65556 w 65556"/>
                <a:gd name="connsiteY3" fmla="*/ 9686 h 10004"/>
                <a:gd name="connsiteX0" fmla="*/ 65556 w 65556"/>
                <a:gd name="connsiteY0" fmla="*/ 9686 h 10140"/>
                <a:gd name="connsiteX1" fmla="*/ 63137 w 65556"/>
                <a:gd name="connsiteY1" fmla="*/ 10 h 10140"/>
                <a:gd name="connsiteX2" fmla="*/ 55580 w 65556"/>
                <a:gd name="connsiteY2" fmla="*/ 8380 h 10140"/>
                <a:gd name="connsiteX3" fmla="*/ 65556 w 65556"/>
                <a:gd name="connsiteY3" fmla="*/ 9686 h 10140"/>
                <a:gd name="connsiteX0" fmla="*/ 64984 w 64984"/>
                <a:gd name="connsiteY0" fmla="*/ 10088 h 10491"/>
                <a:gd name="connsiteX1" fmla="*/ 63137 w 64984"/>
                <a:gd name="connsiteY1" fmla="*/ 10 h 10491"/>
                <a:gd name="connsiteX2" fmla="*/ 55580 w 64984"/>
                <a:gd name="connsiteY2" fmla="*/ 8380 h 10491"/>
                <a:gd name="connsiteX3" fmla="*/ 64984 w 64984"/>
                <a:gd name="connsiteY3" fmla="*/ 10088 h 10491"/>
                <a:gd name="connsiteX0" fmla="*/ 64984 w 64984"/>
                <a:gd name="connsiteY0" fmla="*/ 10088 h 10411"/>
                <a:gd name="connsiteX1" fmla="*/ 63137 w 64984"/>
                <a:gd name="connsiteY1" fmla="*/ 10 h 10411"/>
                <a:gd name="connsiteX2" fmla="*/ 55580 w 64984"/>
                <a:gd name="connsiteY2" fmla="*/ 8380 h 10411"/>
                <a:gd name="connsiteX3" fmla="*/ 64984 w 64984"/>
                <a:gd name="connsiteY3" fmla="*/ 10088 h 10411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373 w 80373"/>
                <a:gd name="connsiteY0" fmla="*/ 10131 h 10131"/>
                <a:gd name="connsiteX1" fmla="*/ 78526 w 80373"/>
                <a:gd name="connsiteY1" fmla="*/ 53 h 10131"/>
                <a:gd name="connsiteX2" fmla="*/ 51392 w 80373"/>
                <a:gd name="connsiteY2" fmla="*/ 7671 h 10131"/>
                <a:gd name="connsiteX3" fmla="*/ 80373 w 80373"/>
                <a:gd name="connsiteY3" fmla="*/ 10131 h 10131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357 w 62357"/>
                <a:gd name="connsiteY0" fmla="*/ 9891 h 9891"/>
                <a:gd name="connsiteX1" fmla="*/ 61114 w 62357"/>
                <a:gd name="connsiteY1" fmla="*/ 48 h 9891"/>
                <a:gd name="connsiteX2" fmla="*/ 33980 w 62357"/>
                <a:gd name="connsiteY2" fmla="*/ 7666 h 9891"/>
                <a:gd name="connsiteX3" fmla="*/ 62357 w 62357"/>
                <a:gd name="connsiteY3" fmla="*/ 9891 h 9891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267 w 10403"/>
                <a:gd name="connsiteY0" fmla="*/ 9740 h 9740"/>
                <a:gd name="connsiteX1" fmla="*/ 9801 w 10403"/>
                <a:gd name="connsiteY1" fmla="*/ 49 h 9740"/>
                <a:gd name="connsiteX2" fmla="*/ 5449 w 10403"/>
                <a:gd name="connsiteY2" fmla="*/ 7750 h 9740"/>
                <a:gd name="connsiteX3" fmla="*/ 10267 w 10403"/>
                <a:gd name="connsiteY3" fmla="*/ 9740 h 9740"/>
                <a:gd name="connsiteX0" fmla="*/ 9564 w 9745"/>
                <a:gd name="connsiteY0" fmla="*/ 9865 h 9865"/>
                <a:gd name="connsiteX1" fmla="*/ 9421 w 9745"/>
                <a:gd name="connsiteY1" fmla="*/ 50 h 9865"/>
                <a:gd name="connsiteX2" fmla="*/ 5238 w 9745"/>
                <a:gd name="connsiteY2" fmla="*/ 7957 h 9865"/>
                <a:gd name="connsiteX3" fmla="*/ 9564 w 9745"/>
                <a:gd name="connsiteY3" fmla="*/ 9865 h 9865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9833 w 10120"/>
                <a:gd name="connsiteY0" fmla="*/ 10175 h 10175"/>
                <a:gd name="connsiteX1" fmla="*/ 9984 w 10120"/>
                <a:gd name="connsiteY1" fmla="*/ 51 h 10175"/>
                <a:gd name="connsiteX2" fmla="*/ 5691 w 10120"/>
                <a:gd name="connsiteY2" fmla="*/ 8066 h 10175"/>
                <a:gd name="connsiteX3" fmla="*/ 9833 w 10120"/>
                <a:gd name="connsiteY3" fmla="*/ 10175 h 10175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8463 w 18581"/>
                <a:gd name="connsiteY0" fmla="*/ 10150 h 10150"/>
                <a:gd name="connsiteX1" fmla="*/ 17855 w 18581"/>
                <a:gd name="connsiteY1" fmla="*/ 0 h 10150"/>
                <a:gd name="connsiteX2" fmla="*/ 12596 w 18581"/>
                <a:gd name="connsiteY2" fmla="*/ 7942 h 10150"/>
                <a:gd name="connsiteX3" fmla="*/ 18463 w 18581"/>
                <a:gd name="connsiteY3" fmla="*/ 10150 h 10150"/>
                <a:gd name="connsiteX0" fmla="*/ 608 w 726"/>
                <a:gd name="connsiteY0" fmla="*/ 10150 h 10150"/>
                <a:gd name="connsiteX1" fmla="*/ 0 w 726"/>
                <a:gd name="connsiteY1" fmla="*/ 0 h 10150"/>
                <a:gd name="connsiteX2" fmla="*/ 608 w 726"/>
                <a:gd name="connsiteY2" fmla="*/ 10150 h 10150"/>
                <a:gd name="connsiteX0" fmla="*/ 59658 w 61295"/>
                <a:gd name="connsiteY0" fmla="*/ 10000 h 10000"/>
                <a:gd name="connsiteX1" fmla="*/ 51283 w 61295"/>
                <a:gd name="connsiteY1" fmla="*/ 0 h 10000"/>
                <a:gd name="connsiteX2" fmla="*/ 59658 w 61295"/>
                <a:gd name="connsiteY2" fmla="*/ 10000 h 10000"/>
                <a:gd name="connsiteX0" fmla="*/ 59658 w 84651"/>
                <a:gd name="connsiteY0" fmla="*/ 10000 h 10000"/>
                <a:gd name="connsiteX1" fmla="*/ 51283 w 84651"/>
                <a:gd name="connsiteY1" fmla="*/ 0 h 10000"/>
                <a:gd name="connsiteX2" fmla="*/ 59658 w 84651"/>
                <a:gd name="connsiteY2" fmla="*/ 10000 h 10000"/>
                <a:gd name="connsiteX0" fmla="*/ 148647 w 173640"/>
                <a:gd name="connsiteY0" fmla="*/ 10000 h 10000"/>
                <a:gd name="connsiteX1" fmla="*/ 140272 w 173640"/>
                <a:gd name="connsiteY1" fmla="*/ 0 h 10000"/>
                <a:gd name="connsiteX2" fmla="*/ 148647 w 173640"/>
                <a:gd name="connsiteY2" fmla="*/ 10000 h 10000"/>
                <a:gd name="connsiteX0" fmla="*/ 148647 w 153064"/>
                <a:gd name="connsiteY0" fmla="*/ 10000 h 10000"/>
                <a:gd name="connsiteX1" fmla="*/ 140272 w 153064"/>
                <a:gd name="connsiteY1" fmla="*/ 0 h 10000"/>
                <a:gd name="connsiteX2" fmla="*/ 148647 w 153064"/>
                <a:gd name="connsiteY2" fmla="*/ 10000 h 10000"/>
                <a:gd name="connsiteX0" fmla="*/ 148647 w 148647"/>
                <a:gd name="connsiteY0" fmla="*/ 10000 h 10000"/>
                <a:gd name="connsiteX1" fmla="*/ 140272 w 148647"/>
                <a:gd name="connsiteY1" fmla="*/ 0 h 10000"/>
                <a:gd name="connsiteX2" fmla="*/ 148647 w 148647"/>
                <a:gd name="connsiteY2" fmla="*/ 10000 h 10000"/>
                <a:gd name="connsiteX0" fmla="*/ 154722 w 154722"/>
                <a:gd name="connsiteY0" fmla="*/ 10000 h 10000"/>
                <a:gd name="connsiteX1" fmla="*/ 146347 w 154722"/>
                <a:gd name="connsiteY1" fmla="*/ 0 h 10000"/>
                <a:gd name="connsiteX2" fmla="*/ 154722 w 154722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3231"/>
                <a:gd name="connsiteY0" fmla="*/ 10000 h 10000"/>
                <a:gd name="connsiteX1" fmla="*/ 144350 w 153231"/>
                <a:gd name="connsiteY1" fmla="*/ 0 h 10000"/>
                <a:gd name="connsiteX2" fmla="*/ 152725 w 153231"/>
                <a:gd name="connsiteY2" fmla="*/ 10000 h 10000"/>
                <a:gd name="connsiteX0" fmla="*/ 152725 w 153930"/>
                <a:gd name="connsiteY0" fmla="*/ 10000 h 10000"/>
                <a:gd name="connsiteX1" fmla="*/ 144350 w 153930"/>
                <a:gd name="connsiteY1" fmla="*/ 0 h 10000"/>
                <a:gd name="connsiteX2" fmla="*/ 152725 w 153930"/>
                <a:gd name="connsiteY2" fmla="*/ 10000 h 10000"/>
                <a:gd name="connsiteX0" fmla="*/ 152725 w 156746"/>
                <a:gd name="connsiteY0" fmla="*/ 10000 h 10000"/>
                <a:gd name="connsiteX1" fmla="*/ 144350 w 156746"/>
                <a:gd name="connsiteY1" fmla="*/ 0 h 10000"/>
                <a:gd name="connsiteX2" fmla="*/ 152725 w 156746"/>
                <a:gd name="connsiteY2" fmla="*/ 10000 h 10000"/>
                <a:gd name="connsiteX0" fmla="*/ 156368 w 160389"/>
                <a:gd name="connsiteY0" fmla="*/ 10000 h 10000"/>
                <a:gd name="connsiteX1" fmla="*/ 147993 w 160389"/>
                <a:gd name="connsiteY1" fmla="*/ 0 h 10000"/>
                <a:gd name="connsiteX2" fmla="*/ 156368 w 160389"/>
                <a:gd name="connsiteY2" fmla="*/ 10000 h 10000"/>
                <a:gd name="connsiteX0" fmla="*/ 159522 w 163543"/>
                <a:gd name="connsiteY0" fmla="*/ 10000 h 10000"/>
                <a:gd name="connsiteX1" fmla="*/ 151147 w 163543"/>
                <a:gd name="connsiteY1" fmla="*/ 0 h 10000"/>
                <a:gd name="connsiteX2" fmla="*/ 159522 w 163543"/>
                <a:gd name="connsiteY2" fmla="*/ 10000 h 10000"/>
                <a:gd name="connsiteX0" fmla="*/ 164492 w 168513"/>
                <a:gd name="connsiteY0" fmla="*/ 10000 h 10000"/>
                <a:gd name="connsiteX1" fmla="*/ 156117 w 168513"/>
                <a:gd name="connsiteY1" fmla="*/ 0 h 10000"/>
                <a:gd name="connsiteX2" fmla="*/ 164492 w 168513"/>
                <a:gd name="connsiteY2" fmla="*/ 10000 h 10000"/>
                <a:gd name="connsiteX0" fmla="*/ 157865 w 166869"/>
                <a:gd name="connsiteY0" fmla="*/ 10241 h 10241"/>
                <a:gd name="connsiteX1" fmla="*/ 161044 w 166869"/>
                <a:gd name="connsiteY1" fmla="*/ 0 h 10241"/>
                <a:gd name="connsiteX2" fmla="*/ 157865 w 166869"/>
                <a:gd name="connsiteY2" fmla="*/ 10241 h 102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6869" h="10241">
                  <a:moveTo>
                    <a:pt x="157865" y="10241"/>
                  </a:moveTo>
                  <a:cubicBezTo>
                    <a:pt x="166687" y="7400"/>
                    <a:pt x="171237" y="2927"/>
                    <a:pt x="161044" y="0"/>
                  </a:cubicBezTo>
                  <a:cubicBezTo>
                    <a:pt x="-90146" y="1558"/>
                    <a:pt x="-12963" y="7628"/>
                    <a:pt x="157865" y="10241"/>
                  </a:cubicBezTo>
                  <a:close/>
                </a:path>
              </a:pathLst>
            </a:custGeom>
            <a:gradFill flip="none" rotWithShape="1">
              <a:gsLst>
                <a:gs pos="20000">
                  <a:srgbClr val="DFDFDF"/>
                </a:gs>
                <a:gs pos="0">
                  <a:sysClr val="window" lastClr="FFFFFF">
                    <a:lumMod val="95000"/>
                  </a:sysClr>
                </a:gs>
                <a:gs pos="97000">
                  <a:sysClr val="window" lastClr="FFFFFF">
                    <a:lumMod val="65000"/>
                  </a:sysClr>
                </a:gs>
                <a:gs pos="69000">
                  <a:sysClr val="windowText" lastClr="000000">
                    <a:lumMod val="50000"/>
                    <a:lumOff val="50000"/>
                  </a:sysClr>
                </a:gs>
                <a:gs pos="84000">
                  <a:sysClr val="window" lastClr="FFFFFF">
                    <a:lumMod val="95000"/>
                  </a:sysClr>
                </a:gs>
              </a:gsLst>
              <a:lin ang="0" scaled="1"/>
              <a:tileRect/>
            </a:gradFill>
            <a:ln w="25400" cap="flat" cmpd="sng" algn="ctr">
              <a:noFill/>
              <a:prstDash val="solid"/>
            </a:ln>
            <a:effectLst>
              <a:outerShdw blurRad="177800" dist="38100" dir="720000" algn="l" rotWithShape="0">
                <a:prstClr val="black">
                  <a:alpha val="63000"/>
                </a:prstClr>
              </a:outerShdw>
            </a:effectLst>
          </p:spPr>
          <p:txBody>
            <a:bodyPr rtlCol="0" anchor="ctr"/>
            <a:lstStyle/>
            <a:p>
              <a:pPr algn="ctr">
                <a:defRPr/>
              </a:pPr>
              <a:endParaRPr lang="en-US" sz="1200" kern="0">
                <a:solidFill>
                  <a:sysClr val="window" lastClr="FFFFFF"/>
                </a:solidFill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9592047" y="-116888"/>
              <a:ext cx="2617416" cy="1048170"/>
            </a:xfrm>
            <a:prstGeom prst="rect">
              <a:avLst/>
            </a:prstGeom>
            <a:noFill/>
          </p:spPr>
          <p:txBody>
            <a:bodyPr wrap="square" lIns="432044" tIns="216022" rIns="432044" bIns="216022">
              <a:spAutoFit/>
            </a:bodyPr>
            <a:lstStyle>
              <a:defPPr>
                <a:defRPr lang="ar-EG"/>
              </a:defPPr>
              <a:lvl1pPr marL="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3" rtl="0">
                <a:spcBef>
                  <a:spcPct val="0"/>
                </a:spcBef>
                <a:defRPr/>
              </a:pPr>
              <a:r>
                <a:rPr lang="en-US" sz="1400" cap="small" dirty="0" smtClean="0">
                  <a:ln w="12700">
                    <a:noFill/>
                  </a:ln>
                  <a:solidFill>
                    <a:prstClr val="black"/>
                  </a:solidFill>
                  <a:latin typeface="Book Antiqua" pitchFamily="18" charset="0"/>
                  <a:cs typeface="Diwani Letter" pitchFamily="2" charset="-78"/>
                </a:rPr>
                <a:t>Results </a:t>
              </a:r>
              <a:endParaRPr lang="ar-EG" sz="1200" cap="small" dirty="0">
                <a:ln w="12700">
                  <a:noFill/>
                </a:ln>
                <a:solidFill>
                  <a:prstClr val="black"/>
                </a:solidFill>
                <a:latin typeface="Book Antiqua" pitchFamily="18" charset="0"/>
                <a:cs typeface="Diwani Letter" pitchFamily="2" charset="-78"/>
              </a:endParaRPr>
            </a:p>
          </p:txBody>
        </p:sp>
      </p:grpSp>
      <p:sp>
        <p:nvSpPr>
          <p:cNvPr id="12" name="Rectangle 11"/>
          <p:cNvSpPr/>
          <p:nvPr/>
        </p:nvSpPr>
        <p:spPr>
          <a:xfrm>
            <a:off x="4943635" y="2664314"/>
            <a:ext cx="6647268" cy="1484766"/>
          </a:xfrm>
          <a:prstGeom prst="rect">
            <a:avLst/>
          </a:prstGeom>
          <a:solidFill>
            <a:schemeClr val="tx1">
              <a:alpha val="7000"/>
            </a:schemeClr>
          </a:solidFill>
          <a:ln w="19050" cap="flat" cmpd="sng" algn="ctr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18900000" scaled="1"/>
              <a:tileRect/>
            </a:gra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l" rtl="0"/>
            <a:endParaRPr lang="ar-EG" sz="3600" kern="0">
              <a:solidFill>
                <a:sysClr val="window" lastClr="FFFFFF"/>
              </a:solidFill>
              <a:latin typeface="Cambria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730522" y="3072287"/>
            <a:ext cx="9207542" cy="576248"/>
          </a:xfrm>
          <a:prstGeom prst="rect">
            <a:avLst/>
          </a:prstGeom>
          <a:noFill/>
          <a:ln>
            <a:noFill/>
          </a:ln>
          <a:effectLst>
            <a:glow rad="25400">
              <a:schemeClr val="tx1">
                <a:alpha val="99000"/>
              </a:schemeClr>
            </a:glow>
          </a:effectLst>
        </p:spPr>
        <p:txBody>
          <a:bodyPr wrap="square" rtlCol="1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defTabSz="914363" rtl="0">
              <a:lnSpc>
                <a:spcPct val="120000"/>
              </a:lnSpc>
              <a:spcBef>
                <a:spcPct val="0"/>
              </a:spcBef>
              <a:defRPr/>
            </a:pPr>
            <a:r>
              <a:rPr lang="en-US" sz="2800" b="1" kern="0" dirty="0" smtClean="0">
                <a:solidFill>
                  <a:srgbClr val="E8B7B7">
                    <a:lumMod val="20000"/>
                    <a:lumOff val="80000"/>
                  </a:srgbClr>
                </a:solidFill>
                <a:effectLst>
                  <a:glow rad="25400">
                    <a:sysClr val="windowText" lastClr="000000">
                      <a:alpha val="99000"/>
                    </a:sysClr>
                  </a:glow>
                  <a:outerShdw blurRad="50800" dist="38100" dir="2700000" algn="tl" rotWithShape="0">
                    <a:prstClr val="black"/>
                  </a:outerShdw>
                </a:effectLst>
                <a:latin typeface="Book Antiqua" pitchFamily="18" charset="0"/>
                <a:cs typeface="Arial" charset="0"/>
              </a:rPr>
              <a:t>Full Volume 3D Echocardiography</a:t>
            </a:r>
            <a:endParaRPr lang="en-US" sz="2800" b="1" kern="0" dirty="0">
              <a:solidFill>
                <a:srgbClr val="E8B7B7">
                  <a:lumMod val="20000"/>
                  <a:lumOff val="80000"/>
                </a:srgbClr>
              </a:solidFill>
              <a:effectLst>
                <a:glow rad="25400">
                  <a:sysClr val="windowText" lastClr="000000">
                    <a:alpha val="99000"/>
                  </a:sysClr>
                </a:glow>
                <a:outerShdw blurRad="50800" dist="38100" dir="2700000" algn="tl" rotWithShape="0">
                  <a:prstClr val="black"/>
                </a:outerShdw>
              </a:effectLst>
              <a:latin typeface="Book Antiqua" pitchFamily="18" charset="0"/>
              <a:cs typeface="Arial" charset="0"/>
            </a:endParaRPr>
          </a:p>
        </p:txBody>
      </p:sp>
      <p:pic>
        <p:nvPicPr>
          <p:cNvPr id="14" name="Picture 1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574926" y="980728"/>
            <a:ext cx="4759367" cy="47593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Rectangle 14"/>
          <p:cNvSpPr/>
          <p:nvPr/>
        </p:nvSpPr>
        <p:spPr>
          <a:xfrm>
            <a:off x="4219516" y="2733902"/>
            <a:ext cx="3517885" cy="1631202"/>
          </a:xfrm>
          <a:prstGeom prst="rect">
            <a:avLst/>
          </a:prstGeom>
        </p:spPr>
        <p:txBody>
          <a:bodyPr wrap="square" lIns="91427" tIns="45713" rIns="91427" bIns="45713">
            <a:spAutoFit/>
          </a:bodyPr>
          <a:lstStyle/>
          <a:p>
            <a:pPr lvl="0" algn="ctr" defTabSz="914363">
              <a:spcBef>
                <a:spcPct val="0"/>
              </a:spcBef>
              <a:defRPr/>
            </a:pPr>
            <a:r>
              <a:rPr lang="en-US" sz="3400" b="1" kern="0" spc="300" dirty="0">
                <a:solidFill>
                  <a:srgbClr val="B01513"/>
                </a:solidFill>
                <a:latin typeface="Book Antiqua" pitchFamily="18" charset="0"/>
                <a:cs typeface="AF_Unizah " pitchFamily="2" charset="-78"/>
              </a:rPr>
              <a:t>A case of</a:t>
            </a:r>
          </a:p>
          <a:p>
            <a:pPr lvl="0" algn="ctr" defTabSz="914363">
              <a:spcBef>
                <a:spcPct val="0"/>
              </a:spcBef>
              <a:defRPr/>
            </a:pPr>
            <a:r>
              <a:rPr lang="en-US" sz="6600" b="1" kern="0" spc="300" dirty="0" smtClean="0">
                <a:gradFill flip="none" rotWithShape="1">
                  <a:gsLst>
                    <a:gs pos="0">
                      <a:srgbClr val="38979E">
                        <a:shade val="30000"/>
                        <a:satMod val="115000"/>
                      </a:srgbClr>
                    </a:gs>
                    <a:gs pos="50000">
                      <a:srgbClr val="38979E">
                        <a:shade val="67500"/>
                        <a:satMod val="115000"/>
                      </a:srgbClr>
                    </a:gs>
                    <a:gs pos="100000">
                      <a:srgbClr val="38979E">
                        <a:shade val="100000"/>
                        <a:satMod val="115000"/>
                      </a:srgbClr>
                    </a:gs>
                  </a:gsLst>
                  <a:lin ang="16200000" scaled="1"/>
                  <a:tileRect/>
                </a:gradFill>
                <a:latin typeface="Book Antiqua" pitchFamily="18" charset="0"/>
                <a:cs typeface="AF_Unizah " pitchFamily="2" charset="-78"/>
              </a:rPr>
              <a:t>PICMP</a:t>
            </a:r>
            <a:endParaRPr lang="en-US" sz="6000" b="1" kern="0" spc="300" dirty="0">
              <a:gradFill flip="none" rotWithShape="1">
                <a:gsLst>
                  <a:gs pos="0">
                    <a:srgbClr val="38979E">
                      <a:shade val="30000"/>
                      <a:satMod val="115000"/>
                    </a:srgbClr>
                  </a:gs>
                  <a:gs pos="50000">
                    <a:srgbClr val="38979E">
                      <a:shade val="67500"/>
                      <a:satMod val="115000"/>
                    </a:srgbClr>
                  </a:gs>
                  <a:gs pos="100000">
                    <a:srgbClr val="38979E">
                      <a:shade val="100000"/>
                      <a:satMod val="115000"/>
                    </a:srgbClr>
                  </a:gs>
                </a:gsLst>
                <a:lin ang="16200000" scaled="1"/>
                <a:tileRect/>
              </a:gradFill>
              <a:latin typeface="Book Antiqua" pitchFamily="18" charset="0"/>
              <a:cs typeface="AF_Unizah " pitchFamily="2" charset="-78"/>
            </a:endParaRPr>
          </a:p>
        </p:txBody>
      </p:sp>
    </p:spTree>
    <p:extLst>
      <p:ext uri="{BB962C8B-B14F-4D97-AF65-F5344CB8AC3E}">
        <p14:creationId xmlns:p14="http://schemas.microsoft.com/office/powerpoint/2010/main" val="20652309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10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500"/>
                            </p:stCondLst>
                            <p:childTnLst>
                              <p:par>
                                <p:cTn id="13" presetID="35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-0.25 0 E" pathEditMode="relative" ptsTypes="">
                                      <p:cBhvr>
                                        <p:cTn id="14" dur="1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15" presetID="35" presetClass="path" presetSubtype="0" accel="50000" decel="5000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-0.25 0 E" pathEditMode="relative" ptsTypes="">
                                      <p:cBhvr>
                                        <p:cTn id="16" dur="1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" fill="hold">
                            <p:stCondLst>
                              <p:cond delay="2500"/>
                            </p:stCondLst>
                            <p:childTnLst>
                              <p:par>
                                <p:cTn id="1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  <p:bldP spid="13" grpId="0"/>
      <p:bldP spid="15" grpId="0"/>
      <p:bldP spid="15" grpId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Mos 10 PreHamdy Elwasaal2018021717050200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522413" y="0"/>
            <a:ext cx="9144000" cy="6858000"/>
          </a:xfrm>
          <a:prstGeom prst="rect">
            <a:avLst/>
          </a:prstGeom>
        </p:spPr>
      </p:pic>
      <p:sp>
        <p:nvSpPr>
          <p:cNvPr id="23" name="Rectangle 21"/>
          <p:cNvSpPr/>
          <p:nvPr/>
        </p:nvSpPr>
        <p:spPr>
          <a:xfrm flipH="1">
            <a:off x="-1609650" y="1256434"/>
            <a:ext cx="6159175" cy="571150"/>
          </a:xfrm>
          <a:prstGeom prst="round2DiagRect">
            <a:avLst/>
          </a:prstGeom>
          <a:noFill/>
        </p:spPr>
        <p:txBody>
          <a:bodyPr wrap="square" lIns="0" tIns="0" rIns="0" bIns="0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Pre-Pacing </a:t>
            </a:r>
            <a:endParaRPr lang="en-GB" sz="2800" b="1" kern="0" spc="300" dirty="0">
              <a:solidFill>
                <a:prstClr val="white"/>
              </a:solidFill>
              <a:latin typeface="Book Antiqua" panose="020406020503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892166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81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 fullScrn="1">
              <p:cMediaNode vol="80000">
                <p:cTn id="7" repeatCount="indefinite" fill="remove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Mos 10 PostHamdy20180217172833428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558702" y="0"/>
            <a:ext cx="9144000" cy="6858000"/>
          </a:xfrm>
          <a:prstGeom prst="rect">
            <a:avLst/>
          </a:prstGeom>
        </p:spPr>
      </p:pic>
      <p:sp>
        <p:nvSpPr>
          <p:cNvPr id="10" name="Rectangle 21"/>
          <p:cNvSpPr/>
          <p:nvPr/>
        </p:nvSpPr>
        <p:spPr>
          <a:xfrm flipH="1">
            <a:off x="-1591822" y="1249377"/>
            <a:ext cx="6159175" cy="1190894"/>
          </a:xfrm>
          <a:prstGeom prst="round2DiagRect">
            <a:avLst/>
          </a:prstGeom>
          <a:noFill/>
        </p:spPr>
        <p:txBody>
          <a:bodyPr wrap="square" lIns="0" tIns="0" rIns="0" bIns="0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Post-Pacing</a:t>
            </a:r>
          </a:p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At 6 Months</a:t>
            </a:r>
            <a:endParaRPr lang="en-GB" sz="2800" b="1" kern="0" spc="300" dirty="0">
              <a:solidFill>
                <a:prstClr val="white"/>
              </a:solidFill>
              <a:latin typeface="Book Antiqua" panose="020406020503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44911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4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71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 fullScrn="1">
              <p:cMediaNode vol="80000">
                <p:cTn id="11" repeatCount="indefinite" fill="remove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  <p:bldLst>
      <p:bldP spid="10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Mos 10 F_upHamdy Elwasal20180424201244209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522413" y="0"/>
            <a:ext cx="9144000" cy="6858000"/>
          </a:xfrm>
          <a:prstGeom prst="rect">
            <a:avLst/>
          </a:prstGeom>
        </p:spPr>
      </p:pic>
      <p:sp>
        <p:nvSpPr>
          <p:cNvPr id="10" name="Rectangle 21"/>
          <p:cNvSpPr/>
          <p:nvPr/>
        </p:nvSpPr>
        <p:spPr>
          <a:xfrm flipH="1">
            <a:off x="-1579848" y="1484784"/>
            <a:ext cx="6159175" cy="1190894"/>
          </a:xfrm>
          <a:prstGeom prst="round2DiagRect">
            <a:avLst/>
          </a:prstGeom>
          <a:noFill/>
        </p:spPr>
        <p:txBody>
          <a:bodyPr wrap="square" lIns="0" tIns="0" rIns="0" bIns="0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Post-Pacing</a:t>
            </a:r>
          </a:p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At 6 Months</a:t>
            </a:r>
            <a:endParaRPr lang="en-GB" sz="2800" b="1" kern="0" spc="300" dirty="0">
              <a:solidFill>
                <a:prstClr val="white"/>
              </a:solidFill>
              <a:latin typeface="Book Antiqua" panose="020406020503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72623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4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577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 fullScrn="1">
              <p:cMediaNode vol="80000">
                <p:cTn id="11" repeatCount="indefinite" fill="remove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  <p:bldLst>
      <p:bldP spid="10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055646" y="-69119"/>
            <a:ext cx="1998936" cy="814773"/>
            <a:chOff x="9479582" y="-116888"/>
            <a:chExt cx="2729881" cy="1048170"/>
          </a:xfrm>
        </p:grpSpPr>
        <p:sp>
          <p:nvSpPr>
            <p:cNvPr id="4" name="Rectangle 8"/>
            <p:cNvSpPr/>
            <p:nvPr/>
          </p:nvSpPr>
          <p:spPr>
            <a:xfrm rot="5400000" flipH="1">
              <a:off x="10370523" y="-950762"/>
              <a:ext cx="825382" cy="2607264"/>
            </a:xfrm>
            <a:custGeom>
              <a:avLst/>
              <a:gdLst>
                <a:gd name="connsiteX0" fmla="*/ 0 w 381000"/>
                <a:gd name="connsiteY0" fmla="*/ 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0 w 381000"/>
                <a:gd name="connsiteY4" fmla="*/ 0 h 1066800"/>
                <a:gd name="connsiteX0" fmla="*/ 155804 w 381000"/>
                <a:gd name="connsiteY0" fmla="*/ 77413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155804 w 381000"/>
                <a:gd name="connsiteY4" fmla="*/ 77413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2100"/>
                <a:gd name="connsiteY0" fmla="*/ 1066800 h 1266097"/>
                <a:gd name="connsiteX1" fmla="*/ 381000 w 382100"/>
                <a:gd name="connsiteY1" fmla="*/ 0 h 1266097"/>
                <a:gd name="connsiteX2" fmla="*/ 382100 w 382100"/>
                <a:gd name="connsiteY2" fmla="*/ 1266097 h 1266097"/>
                <a:gd name="connsiteX3" fmla="*/ 0 w 382100"/>
                <a:gd name="connsiteY3" fmla="*/ 1066800 h 1266097"/>
                <a:gd name="connsiteX0" fmla="*/ 81205 w 463305"/>
                <a:gd name="connsiteY0" fmla="*/ 1066800 h 1278547"/>
                <a:gd name="connsiteX1" fmla="*/ 462205 w 463305"/>
                <a:gd name="connsiteY1" fmla="*/ 0 h 1278547"/>
                <a:gd name="connsiteX2" fmla="*/ 463305 w 463305"/>
                <a:gd name="connsiteY2" fmla="*/ 1266097 h 1278547"/>
                <a:gd name="connsiteX3" fmla="*/ 81205 w 463305"/>
                <a:gd name="connsiteY3" fmla="*/ 1066800 h 1278547"/>
                <a:gd name="connsiteX0" fmla="*/ 1100 w 1100"/>
                <a:gd name="connsiteY0" fmla="*/ 1266097 h 1266097"/>
                <a:gd name="connsiteX1" fmla="*/ 0 w 1100"/>
                <a:gd name="connsiteY1" fmla="*/ 0 h 1266097"/>
                <a:gd name="connsiteX2" fmla="*/ 1100 w 1100"/>
                <a:gd name="connsiteY2" fmla="*/ 1266097 h 1266097"/>
                <a:gd name="connsiteX0" fmla="*/ 4504727 w 4504727"/>
                <a:gd name="connsiteY0" fmla="*/ 10000 h 10000"/>
                <a:gd name="connsiteX1" fmla="*/ 4494727 w 4504727"/>
                <a:gd name="connsiteY1" fmla="*/ 0 h 10000"/>
                <a:gd name="connsiteX2" fmla="*/ 4504727 w 4504727"/>
                <a:gd name="connsiteY2" fmla="*/ 10000 h 10000"/>
                <a:gd name="connsiteX0" fmla="*/ 4711554 w 4711554"/>
                <a:gd name="connsiteY0" fmla="*/ 10376 h 10376"/>
                <a:gd name="connsiteX1" fmla="*/ 3938749 w 4711554"/>
                <a:gd name="connsiteY1" fmla="*/ 0 h 10376"/>
                <a:gd name="connsiteX2" fmla="*/ 4711554 w 4711554"/>
                <a:gd name="connsiteY2" fmla="*/ 10376 h 10376"/>
                <a:gd name="connsiteX0" fmla="*/ 5453499 w 5453499"/>
                <a:gd name="connsiteY0" fmla="*/ 10376 h 10376"/>
                <a:gd name="connsiteX1" fmla="*/ 4680694 w 5453499"/>
                <a:gd name="connsiteY1" fmla="*/ 0 h 10376"/>
                <a:gd name="connsiteX2" fmla="*/ 5453499 w 5453499"/>
                <a:gd name="connsiteY2" fmla="*/ 10376 h 10376"/>
                <a:gd name="connsiteX0" fmla="*/ 5188217 w 5193990"/>
                <a:gd name="connsiteY0" fmla="*/ 10193 h 10193"/>
                <a:gd name="connsiteX1" fmla="*/ 5193988 w 5193990"/>
                <a:gd name="connsiteY1" fmla="*/ 0 h 10193"/>
                <a:gd name="connsiteX2" fmla="*/ 5188217 w 5193990"/>
                <a:gd name="connsiteY2" fmla="*/ 10193 h 10193"/>
                <a:gd name="connsiteX0" fmla="*/ 5198190 w 5203963"/>
                <a:gd name="connsiteY0" fmla="*/ 10265 h 10265"/>
                <a:gd name="connsiteX1" fmla="*/ 5203961 w 5203963"/>
                <a:gd name="connsiteY1" fmla="*/ 72 h 10265"/>
                <a:gd name="connsiteX2" fmla="*/ 5198190 w 5203963"/>
                <a:gd name="connsiteY2" fmla="*/ 10265 h 10265"/>
                <a:gd name="connsiteX0" fmla="*/ 3303499 w 3309272"/>
                <a:gd name="connsiteY0" fmla="*/ 10194 h 10194"/>
                <a:gd name="connsiteX1" fmla="*/ 3309270 w 3309272"/>
                <a:gd name="connsiteY1" fmla="*/ 1 h 10194"/>
                <a:gd name="connsiteX2" fmla="*/ 3303499 w 3309272"/>
                <a:gd name="connsiteY2" fmla="*/ 10194 h 10194"/>
                <a:gd name="connsiteX0" fmla="*/ 3375826 w 3381599"/>
                <a:gd name="connsiteY0" fmla="*/ 10193 h 10193"/>
                <a:gd name="connsiteX1" fmla="*/ 3381597 w 3381599"/>
                <a:gd name="connsiteY1" fmla="*/ 0 h 10193"/>
                <a:gd name="connsiteX2" fmla="*/ 3375826 w 3381599"/>
                <a:gd name="connsiteY2" fmla="*/ 10193 h 10193"/>
                <a:gd name="connsiteX0" fmla="*/ 3305544 w 3311317"/>
                <a:gd name="connsiteY0" fmla="*/ 10193 h 10193"/>
                <a:gd name="connsiteX1" fmla="*/ 3311315 w 3311317"/>
                <a:gd name="connsiteY1" fmla="*/ 0 h 10193"/>
                <a:gd name="connsiteX2" fmla="*/ 3305544 w 3311317"/>
                <a:gd name="connsiteY2" fmla="*/ 10193 h 10193"/>
                <a:gd name="connsiteX0" fmla="*/ 3358833 w 3358835"/>
                <a:gd name="connsiteY0" fmla="*/ 8987 h 8987"/>
                <a:gd name="connsiteX1" fmla="*/ 3232079 w 3358835"/>
                <a:gd name="connsiteY1" fmla="*/ 0 h 8987"/>
                <a:gd name="connsiteX2" fmla="*/ 3358833 w 3358835"/>
                <a:gd name="connsiteY2" fmla="*/ 8987 h 8987"/>
                <a:gd name="connsiteX0" fmla="*/ 6470 w 6470"/>
                <a:gd name="connsiteY0" fmla="*/ 10000 h 10000"/>
                <a:gd name="connsiteX1" fmla="*/ 6093 w 6470"/>
                <a:gd name="connsiteY1" fmla="*/ 0 h 10000"/>
                <a:gd name="connsiteX2" fmla="*/ 6470 w 6470"/>
                <a:gd name="connsiteY2" fmla="*/ 10000 h 10000"/>
                <a:gd name="connsiteX0" fmla="*/ 9802 w 9802"/>
                <a:gd name="connsiteY0" fmla="*/ 10000 h 10000"/>
                <a:gd name="connsiteX1" fmla="*/ 9219 w 9802"/>
                <a:gd name="connsiteY1" fmla="*/ 0 h 10000"/>
                <a:gd name="connsiteX2" fmla="*/ 9802 w 9802"/>
                <a:gd name="connsiteY2" fmla="*/ 10000 h 10000"/>
                <a:gd name="connsiteX0" fmla="*/ 9298 w 10018"/>
                <a:gd name="connsiteY0" fmla="*/ 10932 h 10932"/>
                <a:gd name="connsiteX1" fmla="*/ 9994 w 10018"/>
                <a:gd name="connsiteY1" fmla="*/ 0 h 10932"/>
                <a:gd name="connsiteX2" fmla="*/ 9298 w 10018"/>
                <a:gd name="connsiteY2" fmla="*/ 10932 h 10932"/>
                <a:gd name="connsiteX0" fmla="*/ 10017 w 10017"/>
                <a:gd name="connsiteY0" fmla="*/ 10384 h 10384"/>
                <a:gd name="connsiteX1" fmla="*/ 9391 w 10017"/>
                <a:gd name="connsiteY1" fmla="*/ 0 h 10384"/>
                <a:gd name="connsiteX2" fmla="*/ 10017 w 10017"/>
                <a:gd name="connsiteY2" fmla="*/ 10384 h 10384"/>
                <a:gd name="connsiteX0" fmla="*/ 4732 w 4732"/>
                <a:gd name="connsiteY0" fmla="*/ 10390 h 11041"/>
                <a:gd name="connsiteX1" fmla="*/ 4106 w 4732"/>
                <a:gd name="connsiteY1" fmla="*/ 6 h 11041"/>
                <a:gd name="connsiteX2" fmla="*/ 3 w 4732"/>
                <a:gd name="connsiteY2" fmla="*/ 8873 h 11041"/>
                <a:gd name="connsiteX3" fmla="*/ 4732 w 4732"/>
                <a:gd name="connsiteY3" fmla="*/ 10390 h 11041"/>
                <a:gd name="connsiteX0" fmla="*/ 5470 w 5470"/>
                <a:gd name="connsiteY0" fmla="*/ 9410 h 10025"/>
                <a:gd name="connsiteX1" fmla="*/ 4147 w 5470"/>
                <a:gd name="connsiteY1" fmla="*/ 5 h 10025"/>
                <a:gd name="connsiteX2" fmla="*/ 13 w 5470"/>
                <a:gd name="connsiteY2" fmla="*/ 8140 h 10025"/>
                <a:gd name="connsiteX3" fmla="*/ 5470 w 5470"/>
                <a:gd name="connsiteY3" fmla="*/ 9410 h 10025"/>
                <a:gd name="connsiteX0" fmla="*/ 10000 w 10000"/>
                <a:gd name="connsiteY0" fmla="*/ 9387 h 9696"/>
                <a:gd name="connsiteX1" fmla="*/ 7581 w 10000"/>
                <a:gd name="connsiteY1" fmla="*/ 5 h 9696"/>
                <a:gd name="connsiteX2" fmla="*/ 24 w 10000"/>
                <a:gd name="connsiteY2" fmla="*/ 8120 h 9696"/>
                <a:gd name="connsiteX3" fmla="*/ 10000 w 10000"/>
                <a:gd name="connsiteY3" fmla="*/ 9387 h 9696"/>
                <a:gd name="connsiteX0" fmla="*/ 65556 w 65556"/>
                <a:gd name="connsiteY0" fmla="*/ 9686 h 10004"/>
                <a:gd name="connsiteX1" fmla="*/ 63137 w 65556"/>
                <a:gd name="connsiteY1" fmla="*/ 10 h 10004"/>
                <a:gd name="connsiteX2" fmla="*/ 55580 w 65556"/>
                <a:gd name="connsiteY2" fmla="*/ 8380 h 10004"/>
                <a:gd name="connsiteX3" fmla="*/ 65556 w 65556"/>
                <a:gd name="connsiteY3" fmla="*/ 9686 h 10004"/>
                <a:gd name="connsiteX0" fmla="*/ 65556 w 65556"/>
                <a:gd name="connsiteY0" fmla="*/ 9686 h 10140"/>
                <a:gd name="connsiteX1" fmla="*/ 63137 w 65556"/>
                <a:gd name="connsiteY1" fmla="*/ 10 h 10140"/>
                <a:gd name="connsiteX2" fmla="*/ 55580 w 65556"/>
                <a:gd name="connsiteY2" fmla="*/ 8380 h 10140"/>
                <a:gd name="connsiteX3" fmla="*/ 65556 w 65556"/>
                <a:gd name="connsiteY3" fmla="*/ 9686 h 10140"/>
                <a:gd name="connsiteX0" fmla="*/ 64984 w 64984"/>
                <a:gd name="connsiteY0" fmla="*/ 10088 h 10491"/>
                <a:gd name="connsiteX1" fmla="*/ 63137 w 64984"/>
                <a:gd name="connsiteY1" fmla="*/ 10 h 10491"/>
                <a:gd name="connsiteX2" fmla="*/ 55580 w 64984"/>
                <a:gd name="connsiteY2" fmla="*/ 8380 h 10491"/>
                <a:gd name="connsiteX3" fmla="*/ 64984 w 64984"/>
                <a:gd name="connsiteY3" fmla="*/ 10088 h 10491"/>
                <a:gd name="connsiteX0" fmla="*/ 64984 w 64984"/>
                <a:gd name="connsiteY0" fmla="*/ 10088 h 10411"/>
                <a:gd name="connsiteX1" fmla="*/ 63137 w 64984"/>
                <a:gd name="connsiteY1" fmla="*/ 10 h 10411"/>
                <a:gd name="connsiteX2" fmla="*/ 55580 w 64984"/>
                <a:gd name="connsiteY2" fmla="*/ 8380 h 10411"/>
                <a:gd name="connsiteX3" fmla="*/ 64984 w 64984"/>
                <a:gd name="connsiteY3" fmla="*/ 10088 h 10411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373 w 80373"/>
                <a:gd name="connsiteY0" fmla="*/ 10131 h 10131"/>
                <a:gd name="connsiteX1" fmla="*/ 78526 w 80373"/>
                <a:gd name="connsiteY1" fmla="*/ 53 h 10131"/>
                <a:gd name="connsiteX2" fmla="*/ 51392 w 80373"/>
                <a:gd name="connsiteY2" fmla="*/ 7671 h 10131"/>
                <a:gd name="connsiteX3" fmla="*/ 80373 w 80373"/>
                <a:gd name="connsiteY3" fmla="*/ 10131 h 10131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357 w 62357"/>
                <a:gd name="connsiteY0" fmla="*/ 9891 h 9891"/>
                <a:gd name="connsiteX1" fmla="*/ 61114 w 62357"/>
                <a:gd name="connsiteY1" fmla="*/ 48 h 9891"/>
                <a:gd name="connsiteX2" fmla="*/ 33980 w 62357"/>
                <a:gd name="connsiteY2" fmla="*/ 7666 h 9891"/>
                <a:gd name="connsiteX3" fmla="*/ 62357 w 62357"/>
                <a:gd name="connsiteY3" fmla="*/ 9891 h 9891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267 w 10403"/>
                <a:gd name="connsiteY0" fmla="*/ 9740 h 9740"/>
                <a:gd name="connsiteX1" fmla="*/ 9801 w 10403"/>
                <a:gd name="connsiteY1" fmla="*/ 49 h 9740"/>
                <a:gd name="connsiteX2" fmla="*/ 5449 w 10403"/>
                <a:gd name="connsiteY2" fmla="*/ 7750 h 9740"/>
                <a:gd name="connsiteX3" fmla="*/ 10267 w 10403"/>
                <a:gd name="connsiteY3" fmla="*/ 9740 h 9740"/>
                <a:gd name="connsiteX0" fmla="*/ 9564 w 9745"/>
                <a:gd name="connsiteY0" fmla="*/ 9865 h 9865"/>
                <a:gd name="connsiteX1" fmla="*/ 9421 w 9745"/>
                <a:gd name="connsiteY1" fmla="*/ 50 h 9865"/>
                <a:gd name="connsiteX2" fmla="*/ 5238 w 9745"/>
                <a:gd name="connsiteY2" fmla="*/ 7957 h 9865"/>
                <a:gd name="connsiteX3" fmla="*/ 9564 w 9745"/>
                <a:gd name="connsiteY3" fmla="*/ 9865 h 9865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9833 w 10120"/>
                <a:gd name="connsiteY0" fmla="*/ 10175 h 10175"/>
                <a:gd name="connsiteX1" fmla="*/ 9984 w 10120"/>
                <a:gd name="connsiteY1" fmla="*/ 51 h 10175"/>
                <a:gd name="connsiteX2" fmla="*/ 5691 w 10120"/>
                <a:gd name="connsiteY2" fmla="*/ 8066 h 10175"/>
                <a:gd name="connsiteX3" fmla="*/ 9833 w 10120"/>
                <a:gd name="connsiteY3" fmla="*/ 10175 h 10175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8463 w 18581"/>
                <a:gd name="connsiteY0" fmla="*/ 10150 h 10150"/>
                <a:gd name="connsiteX1" fmla="*/ 17855 w 18581"/>
                <a:gd name="connsiteY1" fmla="*/ 0 h 10150"/>
                <a:gd name="connsiteX2" fmla="*/ 12596 w 18581"/>
                <a:gd name="connsiteY2" fmla="*/ 7942 h 10150"/>
                <a:gd name="connsiteX3" fmla="*/ 18463 w 18581"/>
                <a:gd name="connsiteY3" fmla="*/ 10150 h 10150"/>
                <a:gd name="connsiteX0" fmla="*/ 608 w 726"/>
                <a:gd name="connsiteY0" fmla="*/ 10150 h 10150"/>
                <a:gd name="connsiteX1" fmla="*/ 0 w 726"/>
                <a:gd name="connsiteY1" fmla="*/ 0 h 10150"/>
                <a:gd name="connsiteX2" fmla="*/ 608 w 726"/>
                <a:gd name="connsiteY2" fmla="*/ 10150 h 10150"/>
                <a:gd name="connsiteX0" fmla="*/ 59658 w 61295"/>
                <a:gd name="connsiteY0" fmla="*/ 10000 h 10000"/>
                <a:gd name="connsiteX1" fmla="*/ 51283 w 61295"/>
                <a:gd name="connsiteY1" fmla="*/ 0 h 10000"/>
                <a:gd name="connsiteX2" fmla="*/ 59658 w 61295"/>
                <a:gd name="connsiteY2" fmla="*/ 10000 h 10000"/>
                <a:gd name="connsiteX0" fmla="*/ 59658 w 84651"/>
                <a:gd name="connsiteY0" fmla="*/ 10000 h 10000"/>
                <a:gd name="connsiteX1" fmla="*/ 51283 w 84651"/>
                <a:gd name="connsiteY1" fmla="*/ 0 h 10000"/>
                <a:gd name="connsiteX2" fmla="*/ 59658 w 84651"/>
                <a:gd name="connsiteY2" fmla="*/ 10000 h 10000"/>
                <a:gd name="connsiteX0" fmla="*/ 148647 w 173640"/>
                <a:gd name="connsiteY0" fmla="*/ 10000 h 10000"/>
                <a:gd name="connsiteX1" fmla="*/ 140272 w 173640"/>
                <a:gd name="connsiteY1" fmla="*/ 0 h 10000"/>
                <a:gd name="connsiteX2" fmla="*/ 148647 w 173640"/>
                <a:gd name="connsiteY2" fmla="*/ 10000 h 10000"/>
                <a:gd name="connsiteX0" fmla="*/ 148647 w 153064"/>
                <a:gd name="connsiteY0" fmla="*/ 10000 h 10000"/>
                <a:gd name="connsiteX1" fmla="*/ 140272 w 153064"/>
                <a:gd name="connsiteY1" fmla="*/ 0 h 10000"/>
                <a:gd name="connsiteX2" fmla="*/ 148647 w 153064"/>
                <a:gd name="connsiteY2" fmla="*/ 10000 h 10000"/>
                <a:gd name="connsiteX0" fmla="*/ 148647 w 148647"/>
                <a:gd name="connsiteY0" fmla="*/ 10000 h 10000"/>
                <a:gd name="connsiteX1" fmla="*/ 140272 w 148647"/>
                <a:gd name="connsiteY1" fmla="*/ 0 h 10000"/>
                <a:gd name="connsiteX2" fmla="*/ 148647 w 148647"/>
                <a:gd name="connsiteY2" fmla="*/ 10000 h 10000"/>
                <a:gd name="connsiteX0" fmla="*/ 154722 w 154722"/>
                <a:gd name="connsiteY0" fmla="*/ 10000 h 10000"/>
                <a:gd name="connsiteX1" fmla="*/ 146347 w 154722"/>
                <a:gd name="connsiteY1" fmla="*/ 0 h 10000"/>
                <a:gd name="connsiteX2" fmla="*/ 154722 w 154722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3231"/>
                <a:gd name="connsiteY0" fmla="*/ 10000 h 10000"/>
                <a:gd name="connsiteX1" fmla="*/ 144350 w 153231"/>
                <a:gd name="connsiteY1" fmla="*/ 0 h 10000"/>
                <a:gd name="connsiteX2" fmla="*/ 152725 w 153231"/>
                <a:gd name="connsiteY2" fmla="*/ 10000 h 10000"/>
                <a:gd name="connsiteX0" fmla="*/ 152725 w 153930"/>
                <a:gd name="connsiteY0" fmla="*/ 10000 h 10000"/>
                <a:gd name="connsiteX1" fmla="*/ 144350 w 153930"/>
                <a:gd name="connsiteY1" fmla="*/ 0 h 10000"/>
                <a:gd name="connsiteX2" fmla="*/ 152725 w 153930"/>
                <a:gd name="connsiteY2" fmla="*/ 10000 h 10000"/>
                <a:gd name="connsiteX0" fmla="*/ 152725 w 156746"/>
                <a:gd name="connsiteY0" fmla="*/ 10000 h 10000"/>
                <a:gd name="connsiteX1" fmla="*/ 144350 w 156746"/>
                <a:gd name="connsiteY1" fmla="*/ 0 h 10000"/>
                <a:gd name="connsiteX2" fmla="*/ 152725 w 156746"/>
                <a:gd name="connsiteY2" fmla="*/ 10000 h 10000"/>
                <a:gd name="connsiteX0" fmla="*/ 156368 w 160389"/>
                <a:gd name="connsiteY0" fmla="*/ 10000 h 10000"/>
                <a:gd name="connsiteX1" fmla="*/ 147993 w 160389"/>
                <a:gd name="connsiteY1" fmla="*/ 0 h 10000"/>
                <a:gd name="connsiteX2" fmla="*/ 156368 w 160389"/>
                <a:gd name="connsiteY2" fmla="*/ 10000 h 10000"/>
                <a:gd name="connsiteX0" fmla="*/ 159522 w 163543"/>
                <a:gd name="connsiteY0" fmla="*/ 10000 h 10000"/>
                <a:gd name="connsiteX1" fmla="*/ 151147 w 163543"/>
                <a:gd name="connsiteY1" fmla="*/ 0 h 10000"/>
                <a:gd name="connsiteX2" fmla="*/ 159522 w 163543"/>
                <a:gd name="connsiteY2" fmla="*/ 10000 h 10000"/>
                <a:gd name="connsiteX0" fmla="*/ 164492 w 168513"/>
                <a:gd name="connsiteY0" fmla="*/ 10000 h 10000"/>
                <a:gd name="connsiteX1" fmla="*/ 156117 w 168513"/>
                <a:gd name="connsiteY1" fmla="*/ 0 h 10000"/>
                <a:gd name="connsiteX2" fmla="*/ 164492 w 168513"/>
                <a:gd name="connsiteY2" fmla="*/ 10000 h 10000"/>
                <a:gd name="connsiteX0" fmla="*/ 157865 w 166869"/>
                <a:gd name="connsiteY0" fmla="*/ 10241 h 10241"/>
                <a:gd name="connsiteX1" fmla="*/ 161044 w 166869"/>
                <a:gd name="connsiteY1" fmla="*/ 0 h 10241"/>
                <a:gd name="connsiteX2" fmla="*/ 157865 w 166869"/>
                <a:gd name="connsiteY2" fmla="*/ 10241 h 102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6869" h="10241">
                  <a:moveTo>
                    <a:pt x="157865" y="10241"/>
                  </a:moveTo>
                  <a:cubicBezTo>
                    <a:pt x="166687" y="7400"/>
                    <a:pt x="171237" y="2927"/>
                    <a:pt x="161044" y="0"/>
                  </a:cubicBezTo>
                  <a:cubicBezTo>
                    <a:pt x="-90146" y="1558"/>
                    <a:pt x="-12963" y="7628"/>
                    <a:pt x="157865" y="10241"/>
                  </a:cubicBezTo>
                  <a:close/>
                </a:path>
              </a:pathLst>
            </a:custGeom>
            <a:gradFill flip="none" rotWithShape="1">
              <a:gsLst>
                <a:gs pos="20000">
                  <a:srgbClr val="DFDFDF"/>
                </a:gs>
                <a:gs pos="0">
                  <a:sysClr val="window" lastClr="FFFFFF">
                    <a:lumMod val="95000"/>
                  </a:sysClr>
                </a:gs>
                <a:gs pos="97000">
                  <a:sysClr val="window" lastClr="FFFFFF">
                    <a:lumMod val="65000"/>
                  </a:sysClr>
                </a:gs>
                <a:gs pos="69000">
                  <a:sysClr val="windowText" lastClr="000000">
                    <a:lumMod val="50000"/>
                    <a:lumOff val="50000"/>
                  </a:sysClr>
                </a:gs>
                <a:gs pos="84000">
                  <a:sysClr val="window" lastClr="FFFFFF">
                    <a:lumMod val="95000"/>
                  </a:sysClr>
                </a:gs>
              </a:gsLst>
              <a:lin ang="0" scaled="1"/>
              <a:tileRect/>
            </a:gradFill>
            <a:ln w="25400" cap="flat" cmpd="sng" algn="ctr">
              <a:noFill/>
              <a:prstDash val="solid"/>
            </a:ln>
            <a:effectLst>
              <a:outerShdw blurRad="177800" dist="38100" dir="720000" algn="l" rotWithShape="0">
                <a:prstClr val="black">
                  <a:alpha val="63000"/>
                </a:prstClr>
              </a:outerShdw>
            </a:effectLst>
          </p:spPr>
          <p:txBody>
            <a:bodyPr rtlCol="0" anchor="ctr"/>
            <a:lstStyle/>
            <a:p>
              <a:pPr algn="ctr">
                <a:defRPr/>
              </a:pPr>
              <a:endParaRPr lang="en-US" sz="1200" kern="0">
                <a:solidFill>
                  <a:sysClr val="window" lastClr="FFFFFF"/>
                </a:solidFill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9592047" y="-116888"/>
              <a:ext cx="2617416" cy="1048170"/>
            </a:xfrm>
            <a:prstGeom prst="rect">
              <a:avLst/>
            </a:prstGeom>
            <a:noFill/>
          </p:spPr>
          <p:txBody>
            <a:bodyPr wrap="square" lIns="432044" tIns="216022" rIns="432044" bIns="216022">
              <a:spAutoFit/>
            </a:bodyPr>
            <a:lstStyle>
              <a:defPPr>
                <a:defRPr lang="ar-EG"/>
              </a:defPPr>
              <a:lvl1pPr marL="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3" rtl="0">
                <a:spcBef>
                  <a:spcPct val="0"/>
                </a:spcBef>
                <a:defRPr/>
              </a:pPr>
              <a:r>
                <a:rPr lang="en-US" sz="1400" cap="small" dirty="0" smtClean="0">
                  <a:ln w="12700">
                    <a:noFill/>
                  </a:ln>
                  <a:solidFill>
                    <a:prstClr val="black"/>
                  </a:solidFill>
                  <a:latin typeface="Book Antiqua" pitchFamily="18" charset="0"/>
                  <a:cs typeface="Diwani Letter" pitchFamily="2" charset="-78"/>
                </a:rPr>
                <a:t>Results </a:t>
              </a:r>
              <a:endParaRPr lang="ar-EG" sz="1200" cap="small" dirty="0">
                <a:ln w="12700">
                  <a:noFill/>
                </a:ln>
                <a:solidFill>
                  <a:prstClr val="black"/>
                </a:solidFill>
                <a:latin typeface="Book Antiqua" pitchFamily="18" charset="0"/>
                <a:cs typeface="Diwani Letter" pitchFamily="2" charset="-78"/>
              </a:endParaRPr>
            </a:p>
          </p:txBody>
        </p:sp>
      </p:grpSp>
      <p:sp>
        <p:nvSpPr>
          <p:cNvPr id="7" name="Rectangle 6"/>
          <p:cNvSpPr/>
          <p:nvPr/>
        </p:nvSpPr>
        <p:spPr>
          <a:xfrm>
            <a:off x="4943635" y="2664314"/>
            <a:ext cx="6647268" cy="1484766"/>
          </a:xfrm>
          <a:prstGeom prst="rect">
            <a:avLst/>
          </a:prstGeom>
          <a:solidFill>
            <a:schemeClr val="tx1">
              <a:alpha val="7000"/>
            </a:schemeClr>
          </a:solidFill>
          <a:ln w="19050" cap="flat" cmpd="sng" algn="ctr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18900000" scaled="1"/>
              <a:tileRect/>
            </a:gra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l" rtl="0"/>
            <a:endParaRPr lang="ar-EG" sz="3600" kern="0">
              <a:solidFill>
                <a:sysClr val="window" lastClr="FFFFFF"/>
              </a:solidFill>
              <a:latin typeface="Cambria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584408" y="3153133"/>
            <a:ext cx="9207542" cy="576248"/>
          </a:xfrm>
          <a:prstGeom prst="rect">
            <a:avLst/>
          </a:prstGeom>
          <a:noFill/>
          <a:ln>
            <a:noFill/>
          </a:ln>
          <a:effectLst>
            <a:glow rad="25400">
              <a:schemeClr val="tx1">
                <a:alpha val="99000"/>
              </a:schemeClr>
            </a:glow>
          </a:effectLst>
        </p:spPr>
        <p:txBody>
          <a:bodyPr wrap="square" rtlCol="1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defTabSz="914363" rtl="0">
              <a:lnSpc>
                <a:spcPct val="120000"/>
              </a:lnSpc>
              <a:spcBef>
                <a:spcPct val="0"/>
              </a:spcBef>
              <a:defRPr/>
            </a:pPr>
            <a:r>
              <a:rPr lang="en-US" sz="2800" b="1" kern="0" dirty="0" smtClean="0">
                <a:solidFill>
                  <a:srgbClr val="E8B7B7">
                    <a:lumMod val="20000"/>
                    <a:lumOff val="80000"/>
                  </a:srgbClr>
                </a:solidFill>
                <a:effectLst>
                  <a:glow rad="25400">
                    <a:sysClr val="windowText" lastClr="000000">
                      <a:alpha val="99000"/>
                    </a:sysClr>
                  </a:glow>
                  <a:outerShdw blurRad="50800" dist="38100" dir="2700000" algn="tl" rotWithShape="0">
                    <a:prstClr val="black"/>
                  </a:outerShdw>
                </a:effectLst>
                <a:latin typeface="Book Antiqua" pitchFamily="18" charset="0"/>
                <a:cs typeface="Arial" charset="0"/>
              </a:rPr>
              <a:t>Global Longitudinal Strain (GLS)</a:t>
            </a:r>
            <a:endParaRPr lang="en-US" sz="2800" b="1" kern="0" dirty="0">
              <a:solidFill>
                <a:srgbClr val="E8B7B7">
                  <a:lumMod val="20000"/>
                  <a:lumOff val="80000"/>
                </a:srgbClr>
              </a:solidFill>
              <a:effectLst>
                <a:glow rad="25400">
                  <a:sysClr val="windowText" lastClr="000000">
                    <a:alpha val="99000"/>
                  </a:sysClr>
                </a:glow>
                <a:outerShdw blurRad="50800" dist="38100" dir="2700000" algn="tl" rotWithShape="0">
                  <a:prstClr val="black"/>
                </a:outerShdw>
              </a:effectLst>
              <a:latin typeface="Book Antiqua" pitchFamily="18" charset="0"/>
              <a:cs typeface="Arial" charset="0"/>
            </a:endParaRPr>
          </a:p>
        </p:txBody>
      </p:sp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574926" y="980728"/>
            <a:ext cx="4759367" cy="47593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Rectangle 9"/>
          <p:cNvSpPr/>
          <p:nvPr/>
        </p:nvSpPr>
        <p:spPr>
          <a:xfrm>
            <a:off x="4219516" y="2733902"/>
            <a:ext cx="3517885" cy="1631202"/>
          </a:xfrm>
          <a:prstGeom prst="rect">
            <a:avLst/>
          </a:prstGeom>
        </p:spPr>
        <p:txBody>
          <a:bodyPr wrap="square" lIns="91427" tIns="45713" rIns="91427" bIns="45713">
            <a:spAutoFit/>
          </a:bodyPr>
          <a:lstStyle/>
          <a:p>
            <a:pPr lvl="0" algn="ctr" defTabSz="914363">
              <a:spcBef>
                <a:spcPct val="0"/>
              </a:spcBef>
              <a:defRPr/>
            </a:pPr>
            <a:r>
              <a:rPr lang="en-US" sz="3400" b="1" kern="0" spc="300" dirty="0">
                <a:solidFill>
                  <a:srgbClr val="B01513"/>
                </a:solidFill>
                <a:latin typeface="Book Antiqua" pitchFamily="18" charset="0"/>
                <a:cs typeface="AF_Unizah " pitchFamily="2" charset="-78"/>
              </a:rPr>
              <a:t>A case of</a:t>
            </a:r>
          </a:p>
          <a:p>
            <a:pPr lvl="0" algn="ctr" defTabSz="914363">
              <a:spcBef>
                <a:spcPct val="0"/>
              </a:spcBef>
              <a:defRPr/>
            </a:pPr>
            <a:r>
              <a:rPr lang="en-US" sz="6600" b="1" kern="0" spc="300" dirty="0" smtClean="0">
                <a:gradFill flip="none" rotWithShape="1">
                  <a:gsLst>
                    <a:gs pos="0">
                      <a:srgbClr val="38979E">
                        <a:shade val="30000"/>
                        <a:satMod val="115000"/>
                      </a:srgbClr>
                    </a:gs>
                    <a:gs pos="50000">
                      <a:srgbClr val="38979E">
                        <a:shade val="67500"/>
                        <a:satMod val="115000"/>
                      </a:srgbClr>
                    </a:gs>
                    <a:gs pos="100000">
                      <a:srgbClr val="38979E">
                        <a:shade val="100000"/>
                        <a:satMod val="115000"/>
                      </a:srgbClr>
                    </a:gs>
                  </a:gsLst>
                  <a:lin ang="16200000" scaled="1"/>
                  <a:tileRect/>
                </a:gradFill>
                <a:latin typeface="Book Antiqua" pitchFamily="18" charset="0"/>
                <a:cs typeface="AF_Unizah " pitchFamily="2" charset="-78"/>
              </a:rPr>
              <a:t>PICMP</a:t>
            </a:r>
            <a:endParaRPr lang="en-US" sz="6000" b="1" kern="0" spc="300" dirty="0">
              <a:gradFill flip="none" rotWithShape="1">
                <a:gsLst>
                  <a:gs pos="0">
                    <a:srgbClr val="38979E">
                      <a:shade val="30000"/>
                      <a:satMod val="115000"/>
                    </a:srgbClr>
                  </a:gs>
                  <a:gs pos="50000">
                    <a:srgbClr val="38979E">
                      <a:shade val="67500"/>
                      <a:satMod val="115000"/>
                    </a:srgbClr>
                  </a:gs>
                  <a:gs pos="100000">
                    <a:srgbClr val="38979E">
                      <a:shade val="100000"/>
                      <a:satMod val="115000"/>
                    </a:srgbClr>
                  </a:gs>
                </a:gsLst>
                <a:lin ang="16200000" scaled="1"/>
                <a:tileRect/>
              </a:gradFill>
              <a:latin typeface="Book Antiqua" pitchFamily="18" charset="0"/>
              <a:cs typeface="AF_Unizah " pitchFamily="2" charset="-78"/>
            </a:endParaRPr>
          </a:p>
        </p:txBody>
      </p:sp>
    </p:spTree>
    <p:extLst>
      <p:ext uri="{BB962C8B-B14F-4D97-AF65-F5344CB8AC3E}">
        <p14:creationId xmlns:p14="http://schemas.microsoft.com/office/powerpoint/2010/main" val="40230317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10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500"/>
                            </p:stCondLst>
                            <p:childTnLst>
                              <p:par>
                                <p:cTn id="13" presetID="35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-0.25 0 E" pathEditMode="relative" ptsTypes="">
                                      <p:cBhvr>
                                        <p:cTn id="14" dur="1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15" presetID="35" presetClass="path" presetSubtype="0" accel="50000" decel="5000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-0.25 0 E" pathEditMode="relative" ptsTypes="">
                                      <p:cBhvr>
                                        <p:cTn id="16" dur="10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" fill="hold">
                            <p:stCondLst>
                              <p:cond delay="2500"/>
                            </p:stCondLst>
                            <p:childTnLst>
                              <p:par>
                                <p:cTn id="18" presetID="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1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2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4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5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  <p:bldP spid="8" grpId="0"/>
      <p:bldP spid="10" grpId="0"/>
      <p:bldP spid="10" grpId="1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8007" y="3395811"/>
            <a:ext cx="5609248" cy="3367879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7254" y="18566"/>
            <a:ext cx="5638722" cy="3377245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86445"/>
            <a:ext cx="6274722" cy="3377245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1"/>
            <a:ext cx="6274722" cy="337724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7073" y="3426663"/>
            <a:ext cx="5913340" cy="3367879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4722" y="49418"/>
            <a:ext cx="5944412" cy="3377245"/>
          </a:xfrm>
          <a:prstGeom prst="rect">
            <a:avLst/>
          </a:prstGeom>
        </p:spPr>
      </p:pic>
      <p:grpSp>
        <p:nvGrpSpPr>
          <p:cNvPr id="11" name="Group 10"/>
          <p:cNvGrpSpPr/>
          <p:nvPr/>
        </p:nvGrpSpPr>
        <p:grpSpPr>
          <a:xfrm>
            <a:off x="3790950" y="3031806"/>
            <a:ext cx="4176466" cy="647573"/>
            <a:chOff x="8607848" y="5498564"/>
            <a:chExt cx="1512334" cy="311214"/>
          </a:xfrm>
        </p:grpSpPr>
        <p:sp>
          <p:nvSpPr>
            <p:cNvPr id="12" name="Rectangle 11"/>
            <p:cNvSpPr/>
            <p:nvPr/>
          </p:nvSpPr>
          <p:spPr>
            <a:xfrm>
              <a:off x="8702734" y="5498564"/>
              <a:ext cx="1326004" cy="311214"/>
            </a:xfrm>
            <a:prstGeom prst="rect">
              <a:avLst/>
            </a:prstGeom>
            <a:gradFill flip="none" rotWithShape="1">
              <a:gsLst>
                <a:gs pos="0">
                  <a:sysClr val="window" lastClr="FFFFFF"/>
                </a:gs>
                <a:gs pos="90000">
                  <a:sysClr val="window" lastClr="FFFFFF">
                    <a:lumMod val="65000"/>
                  </a:sysClr>
                </a:gs>
                <a:gs pos="73000">
                  <a:sysClr val="window" lastClr="FFFFFF"/>
                </a:gs>
                <a:gs pos="50500">
                  <a:sysClr val="window" lastClr="FFFFFF"/>
                </a:gs>
                <a:gs pos="14000">
                  <a:sysClr val="window" lastClr="FFFFFF"/>
                </a:gs>
              </a:gsLst>
              <a:path path="circle">
                <a:fillToRect l="50000" t="50000" r="50000" b="50000"/>
              </a:path>
              <a:tileRect/>
            </a:gradFill>
            <a:ln w="25400" cap="flat" cmpd="sng" algn="ctr">
              <a:noFill/>
              <a:prstDash val="solid"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rtlCol="1" anchor="ctr"/>
            <a:lstStyle/>
            <a:p>
              <a:pPr algn="ctr"/>
              <a:endParaRPr lang="en-GB" sz="2400" kern="0" spc="200">
                <a:solidFill>
                  <a:prstClr val="black"/>
                </a:solidFill>
                <a:latin typeface="Clearly Gothic" pitchFamily="2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8607848" y="5503065"/>
              <a:ext cx="1512334" cy="2570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>
                <a:lnSpc>
                  <a:spcPct val="130000"/>
                </a:lnSpc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GB" sz="2400" b="1" kern="0" spc="300" dirty="0" smtClean="0">
                  <a:solidFill>
                    <a:schemeClr val="bg1"/>
                  </a:solidFill>
                  <a:latin typeface="Book Antiqua" panose="02040602050305030304" pitchFamily="18" charset="0"/>
                </a:rPr>
                <a:t>Pre-Pacing GLS </a:t>
              </a:r>
              <a:endParaRPr lang="en-GB" sz="2400" b="1" kern="0" spc="300" dirty="0">
                <a:solidFill>
                  <a:schemeClr val="bg1"/>
                </a:solidFill>
                <a:latin typeface="Book Antiqua" panose="020406020503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798326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7761" y="3276277"/>
            <a:ext cx="6132652" cy="358172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562" y="22233"/>
            <a:ext cx="6132652" cy="3254043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1560" y="3276276"/>
            <a:ext cx="6040519" cy="358172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057761" cy="3204101"/>
          </a:xfrm>
          <a:prstGeom prst="rect">
            <a:avLst/>
          </a:prstGeom>
        </p:spPr>
      </p:pic>
      <p:grpSp>
        <p:nvGrpSpPr>
          <p:cNvPr id="12" name="Group 11"/>
          <p:cNvGrpSpPr/>
          <p:nvPr/>
        </p:nvGrpSpPr>
        <p:grpSpPr>
          <a:xfrm>
            <a:off x="4017485" y="3024664"/>
            <a:ext cx="3661897" cy="647573"/>
            <a:chOff x="8702734" y="5498564"/>
            <a:chExt cx="1326004" cy="311214"/>
          </a:xfrm>
        </p:grpSpPr>
        <p:sp>
          <p:nvSpPr>
            <p:cNvPr id="13" name="Rectangle 12"/>
            <p:cNvSpPr/>
            <p:nvPr/>
          </p:nvSpPr>
          <p:spPr>
            <a:xfrm>
              <a:off x="8702734" y="5498564"/>
              <a:ext cx="1326004" cy="311214"/>
            </a:xfrm>
            <a:prstGeom prst="rect">
              <a:avLst/>
            </a:prstGeom>
            <a:gradFill flip="none" rotWithShape="1">
              <a:gsLst>
                <a:gs pos="0">
                  <a:sysClr val="window" lastClr="FFFFFF"/>
                </a:gs>
                <a:gs pos="90000">
                  <a:sysClr val="window" lastClr="FFFFFF">
                    <a:lumMod val="65000"/>
                  </a:sysClr>
                </a:gs>
                <a:gs pos="73000">
                  <a:sysClr val="window" lastClr="FFFFFF"/>
                </a:gs>
                <a:gs pos="50500">
                  <a:sysClr val="window" lastClr="FFFFFF"/>
                </a:gs>
                <a:gs pos="14000">
                  <a:sysClr val="window" lastClr="FFFFFF"/>
                </a:gs>
              </a:gsLst>
              <a:path path="circle">
                <a:fillToRect l="50000" t="50000" r="50000" b="50000"/>
              </a:path>
              <a:tileRect/>
            </a:gradFill>
            <a:ln w="25400" cap="flat" cmpd="sng" algn="ctr">
              <a:noFill/>
              <a:prstDash val="solid"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rtlCol="1" anchor="ctr"/>
            <a:lstStyle/>
            <a:p>
              <a:pPr algn="ctr"/>
              <a:endParaRPr lang="en-GB" sz="2400" kern="0" spc="200">
                <a:solidFill>
                  <a:prstClr val="black"/>
                </a:solidFill>
                <a:latin typeface="Clearly Gothic" pitchFamily="2" charset="0"/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8780013" y="5503065"/>
              <a:ext cx="1168004" cy="2570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>
                <a:lnSpc>
                  <a:spcPct val="130000"/>
                </a:lnSpc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GB" sz="2400" b="1" kern="0" spc="300" dirty="0" smtClean="0">
                  <a:solidFill>
                    <a:schemeClr val="bg1"/>
                  </a:solidFill>
                  <a:latin typeface="Book Antiqua" panose="02040602050305030304" pitchFamily="18" charset="0"/>
                </a:rPr>
                <a:t>Post-Pacing GLS </a:t>
              </a:r>
              <a:endParaRPr lang="en-GB" sz="2400" b="1" kern="0" spc="300" dirty="0">
                <a:solidFill>
                  <a:schemeClr val="bg1"/>
                </a:solidFill>
                <a:latin typeface="Book Antiqua" panose="020406020503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276664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9479582" y="-59821"/>
            <a:ext cx="2729881" cy="874353"/>
            <a:chOff x="9479582" y="-59821"/>
            <a:chExt cx="2729881" cy="874353"/>
          </a:xfrm>
        </p:grpSpPr>
        <p:sp>
          <p:nvSpPr>
            <p:cNvPr id="4" name="Rectangle 8"/>
            <p:cNvSpPr/>
            <p:nvPr/>
          </p:nvSpPr>
          <p:spPr>
            <a:xfrm rot="5400000" flipH="1">
              <a:off x="10370523" y="-950762"/>
              <a:ext cx="825382" cy="2607264"/>
            </a:xfrm>
            <a:custGeom>
              <a:avLst/>
              <a:gdLst>
                <a:gd name="connsiteX0" fmla="*/ 0 w 381000"/>
                <a:gd name="connsiteY0" fmla="*/ 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0 w 381000"/>
                <a:gd name="connsiteY4" fmla="*/ 0 h 1066800"/>
                <a:gd name="connsiteX0" fmla="*/ 155804 w 381000"/>
                <a:gd name="connsiteY0" fmla="*/ 77413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155804 w 381000"/>
                <a:gd name="connsiteY4" fmla="*/ 77413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2100"/>
                <a:gd name="connsiteY0" fmla="*/ 1066800 h 1266097"/>
                <a:gd name="connsiteX1" fmla="*/ 381000 w 382100"/>
                <a:gd name="connsiteY1" fmla="*/ 0 h 1266097"/>
                <a:gd name="connsiteX2" fmla="*/ 382100 w 382100"/>
                <a:gd name="connsiteY2" fmla="*/ 1266097 h 1266097"/>
                <a:gd name="connsiteX3" fmla="*/ 0 w 382100"/>
                <a:gd name="connsiteY3" fmla="*/ 1066800 h 1266097"/>
                <a:gd name="connsiteX0" fmla="*/ 81205 w 463305"/>
                <a:gd name="connsiteY0" fmla="*/ 1066800 h 1278547"/>
                <a:gd name="connsiteX1" fmla="*/ 462205 w 463305"/>
                <a:gd name="connsiteY1" fmla="*/ 0 h 1278547"/>
                <a:gd name="connsiteX2" fmla="*/ 463305 w 463305"/>
                <a:gd name="connsiteY2" fmla="*/ 1266097 h 1278547"/>
                <a:gd name="connsiteX3" fmla="*/ 81205 w 463305"/>
                <a:gd name="connsiteY3" fmla="*/ 1066800 h 1278547"/>
                <a:gd name="connsiteX0" fmla="*/ 1100 w 1100"/>
                <a:gd name="connsiteY0" fmla="*/ 1266097 h 1266097"/>
                <a:gd name="connsiteX1" fmla="*/ 0 w 1100"/>
                <a:gd name="connsiteY1" fmla="*/ 0 h 1266097"/>
                <a:gd name="connsiteX2" fmla="*/ 1100 w 1100"/>
                <a:gd name="connsiteY2" fmla="*/ 1266097 h 1266097"/>
                <a:gd name="connsiteX0" fmla="*/ 4504727 w 4504727"/>
                <a:gd name="connsiteY0" fmla="*/ 10000 h 10000"/>
                <a:gd name="connsiteX1" fmla="*/ 4494727 w 4504727"/>
                <a:gd name="connsiteY1" fmla="*/ 0 h 10000"/>
                <a:gd name="connsiteX2" fmla="*/ 4504727 w 4504727"/>
                <a:gd name="connsiteY2" fmla="*/ 10000 h 10000"/>
                <a:gd name="connsiteX0" fmla="*/ 4711554 w 4711554"/>
                <a:gd name="connsiteY0" fmla="*/ 10376 h 10376"/>
                <a:gd name="connsiteX1" fmla="*/ 3938749 w 4711554"/>
                <a:gd name="connsiteY1" fmla="*/ 0 h 10376"/>
                <a:gd name="connsiteX2" fmla="*/ 4711554 w 4711554"/>
                <a:gd name="connsiteY2" fmla="*/ 10376 h 10376"/>
                <a:gd name="connsiteX0" fmla="*/ 5453499 w 5453499"/>
                <a:gd name="connsiteY0" fmla="*/ 10376 h 10376"/>
                <a:gd name="connsiteX1" fmla="*/ 4680694 w 5453499"/>
                <a:gd name="connsiteY1" fmla="*/ 0 h 10376"/>
                <a:gd name="connsiteX2" fmla="*/ 5453499 w 5453499"/>
                <a:gd name="connsiteY2" fmla="*/ 10376 h 10376"/>
                <a:gd name="connsiteX0" fmla="*/ 5188217 w 5193990"/>
                <a:gd name="connsiteY0" fmla="*/ 10193 h 10193"/>
                <a:gd name="connsiteX1" fmla="*/ 5193988 w 5193990"/>
                <a:gd name="connsiteY1" fmla="*/ 0 h 10193"/>
                <a:gd name="connsiteX2" fmla="*/ 5188217 w 5193990"/>
                <a:gd name="connsiteY2" fmla="*/ 10193 h 10193"/>
                <a:gd name="connsiteX0" fmla="*/ 5198190 w 5203963"/>
                <a:gd name="connsiteY0" fmla="*/ 10265 h 10265"/>
                <a:gd name="connsiteX1" fmla="*/ 5203961 w 5203963"/>
                <a:gd name="connsiteY1" fmla="*/ 72 h 10265"/>
                <a:gd name="connsiteX2" fmla="*/ 5198190 w 5203963"/>
                <a:gd name="connsiteY2" fmla="*/ 10265 h 10265"/>
                <a:gd name="connsiteX0" fmla="*/ 3303499 w 3309272"/>
                <a:gd name="connsiteY0" fmla="*/ 10194 h 10194"/>
                <a:gd name="connsiteX1" fmla="*/ 3309270 w 3309272"/>
                <a:gd name="connsiteY1" fmla="*/ 1 h 10194"/>
                <a:gd name="connsiteX2" fmla="*/ 3303499 w 3309272"/>
                <a:gd name="connsiteY2" fmla="*/ 10194 h 10194"/>
                <a:gd name="connsiteX0" fmla="*/ 3375826 w 3381599"/>
                <a:gd name="connsiteY0" fmla="*/ 10193 h 10193"/>
                <a:gd name="connsiteX1" fmla="*/ 3381597 w 3381599"/>
                <a:gd name="connsiteY1" fmla="*/ 0 h 10193"/>
                <a:gd name="connsiteX2" fmla="*/ 3375826 w 3381599"/>
                <a:gd name="connsiteY2" fmla="*/ 10193 h 10193"/>
                <a:gd name="connsiteX0" fmla="*/ 3305544 w 3311317"/>
                <a:gd name="connsiteY0" fmla="*/ 10193 h 10193"/>
                <a:gd name="connsiteX1" fmla="*/ 3311315 w 3311317"/>
                <a:gd name="connsiteY1" fmla="*/ 0 h 10193"/>
                <a:gd name="connsiteX2" fmla="*/ 3305544 w 3311317"/>
                <a:gd name="connsiteY2" fmla="*/ 10193 h 10193"/>
                <a:gd name="connsiteX0" fmla="*/ 3358833 w 3358835"/>
                <a:gd name="connsiteY0" fmla="*/ 8987 h 8987"/>
                <a:gd name="connsiteX1" fmla="*/ 3232079 w 3358835"/>
                <a:gd name="connsiteY1" fmla="*/ 0 h 8987"/>
                <a:gd name="connsiteX2" fmla="*/ 3358833 w 3358835"/>
                <a:gd name="connsiteY2" fmla="*/ 8987 h 8987"/>
                <a:gd name="connsiteX0" fmla="*/ 6470 w 6470"/>
                <a:gd name="connsiteY0" fmla="*/ 10000 h 10000"/>
                <a:gd name="connsiteX1" fmla="*/ 6093 w 6470"/>
                <a:gd name="connsiteY1" fmla="*/ 0 h 10000"/>
                <a:gd name="connsiteX2" fmla="*/ 6470 w 6470"/>
                <a:gd name="connsiteY2" fmla="*/ 10000 h 10000"/>
                <a:gd name="connsiteX0" fmla="*/ 9802 w 9802"/>
                <a:gd name="connsiteY0" fmla="*/ 10000 h 10000"/>
                <a:gd name="connsiteX1" fmla="*/ 9219 w 9802"/>
                <a:gd name="connsiteY1" fmla="*/ 0 h 10000"/>
                <a:gd name="connsiteX2" fmla="*/ 9802 w 9802"/>
                <a:gd name="connsiteY2" fmla="*/ 10000 h 10000"/>
                <a:gd name="connsiteX0" fmla="*/ 9298 w 10018"/>
                <a:gd name="connsiteY0" fmla="*/ 10932 h 10932"/>
                <a:gd name="connsiteX1" fmla="*/ 9994 w 10018"/>
                <a:gd name="connsiteY1" fmla="*/ 0 h 10932"/>
                <a:gd name="connsiteX2" fmla="*/ 9298 w 10018"/>
                <a:gd name="connsiteY2" fmla="*/ 10932 h 10932"/>
                <a:gd name="connsiteX0" fmla="*/ 10017 w 10017"/>
                <a:gd name="connsiteY0" fmla="*/ 10384 h 10384"/>
                <a:gd name="connsiteX1" fmla="*/ 9391 w 10017"/>
                <a:gd name="connsiteY1" fmla="*/ 0 h 10384"/>
                <a:gd name="connsiteX2" fmla="*/ 10017 w 10017"/>
                <a:gd name="connsiteY2" fmla="*/ 10384 h 10384"/>
                <a:gd name="connsiteX0" fmla="*/ 4732 w 4732"/>
                <a:gd name="connsiteY0" fmla="*/ 10390 h 11041"/>
                <a:gd name="connsiteX1" fmla="*/ 4106 w 4732"/>
                <a:gd name="connsiteY1" fmla="*/ 6 h 11041"/>
                <a:gd name="connsiteX2" fmla="*/ 3 w 4732"/>
                <a:gd name="connsiteY2" fmla="*/ 8873 h 11041"/>
                <a:gd name="connsiteX3" fmla="*/ 4732 w 4732"/>
                <a:gd name="connsiteY3" fmla="*/ 10390 h 11041"/>
                <a:gd name="connsiteX0" fmla="*/ 5470 w 5470"/>
                <a:gd name="connsiteY0" fmla="*/ 9410 h 10025"/>
                <a:gd name="connsiteX1" fmla="*/ 4147 w 5470"/>
                <a:gd name="connsiteY1" fmla="*/ 5 h 10025"/>
                <a:gd name="connsiteX2" fmla="*/ 13 w 5470"/>
                <a:gd name="connsiteY2" fmla="*/ 8140 h 10025"/>
                <a:gd name="connsiteX3" fmla="*/ 5470 w 5470"/>
                <a:gd name="connsiteY3" fmla="*/ 9410 h 10025"/>
                <a:gd name="connsiteX0" fmla="*/ 10000 w 10000"/>
                <a:gd name="connsiteY0" fmla="*/ 9387 h 9696"/>
                <a:gd name="connsiteX1" fmla="*/ 7581 w 10000"/>
                <a:gd name="connsiteY1" fmla="*/ 5 h 9696"/>
                <a:gd name="connsiteX2" fmla="*/ 24 w 10000"/>
                <a:gd name="connsiteY2" fmla="*/ 8120 h 9696"/>
                <a:gd name="connsiteX3" fmla="*/ 10000 w 10000"/>
                <a:gd name="connsiteY3" fmla="*/ 9387 h 9696"/>
                <a:gd name="connsiteX0" fmla="*/ 65556 w 65556"/>
                <a:gd name="connsiteY0" fmla="*/ 9686 h 10004"/>
                <a:gd name="connsiteX1" fmla="*/ 63137 w 65556"/>
                <a:gd name="connsiteY1" fmla="*/ 10 h 10004"/>
                <a:gd name="connsiteX2" fmla="*/ 55580 w 65556"/>
                <a:gd name="connsiteY2" fmla="*/ 8380 h 10004"/>
                <a:gd name="connsiteX3" fmla="*/ 65556 w 65556"/>
                <a:gd name="connsiteY3" fmla="*/ 9686 h 10004"/>
                <a:gd name="connsiteX0" fmla="*/ 65556 w 65556"/>
                <a:gd name="connsiteY0" fmla="*/ 9686 h 10140"/>
                <a:gd name="connsiteX1" fmla="*/ 63137 w 65556"/>
                <a:gd name="connsiteY1" fmla="*/ 10 h 10140"/>
                <a:gd name="connsiteX2" fmla="*/ 55580 w 65556"/>
                <a:gd name="connsiteY2" fmla="*/ 8380 h 10140"/>
                <a:gd name="connsiteX3" fmla="*/ 65556 w 65556"/>
                <a:gd name="connsiteY3" fmla="*/ 9686 h 10140"/>
                <a:gd name="connsiteX0" fmla="*/ 64984 w 64984"/>
                <a:gd name="connsiteY0" fmla="*/ 10088 h 10491"/>
                <a:gd name="connsiteX1" fmla="*/ 63137 w 64984"/>
                <a:gd name="connsiteY1" fmla="*/ 10 h 10491"/>
                <a:gd name="connsiteX2" fmla="*/ 55580 w 64984"/>
                <a:gd name="connsiteY2" fmla="*/ 8380 h 10491"/>
                <a:gd name="connsiteX3" fmla="*/ 64984 w 64984"/>
                <a:gd name="connsiteY3" fmla="*/ 10088 h 10491"/>
                <a:gd name="connsiteX0" fmla="*/ 64984 w 64984"/>
                <a:gd name="connsiteY0" fmla="*/ 10088 h 10411"/>
                <a:gd name="connsiteX1" fmla="*/ 63137 w 64984"/>
                <a:gd name="connsiteY1" fmla="*/ 10 h 10411"/>
                <a:gd name="connsiteX2" fmla="*/ 55580 w 64984"/>
                <a:gd name="connsiteY2" fmla="*/ 8380 h 10411"/>
                <a:gd name="connsiteX3" fmla="*/ 64984 w 64984"/>
                <a:gd name="connsiteY3" fmla="*/ 10088 h 10411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373 w 80373"/>
                <a:gd name="connsiteY0" fmla="*/ 10131 h 10131"/>
                <a:gd name="connsiteX1" fmla="*/ 78526 w 80373"/>
                <a:gd name="connsiteY1" fmla="*/ 53 h 10131"/>
                <a:gd name="connsiteX2" fmla="*/ 51392 w 80373"/>
                <a:gd name="connsiteY2" fmla="*/ 7671 h 10131"/>
                <a:gd name="connsiteX3" fmla="*/ 80373 w 80373"/>
                <a:gd name="connsiteY3" fmla="*/ 10131 h 10131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357 w 62357"/>
                <a:gd name="connsiteY0" fmla="*/ 9891 h 9891"/>
                <a:gd name="connsiteX1" fmla="*/ 61114 w 62357"/>
                <a:gd name="connsiteY1" fmla="*/ 48 h 9891"/>
                <a:gd name="connsiteX2" fmla="*/ 33980 w 62357"/>
                <a:gd name="connsiteY2" fmla="*/ 7666 h 9891"/>
                <a:gd name="connsiteX3" fmla="*/ 62357 w 62357"/>
                <a:gd name="connsiteY3" fmla="*/ 9891 h 9891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267 w 10403"/>
                <a:gd name="connsiteY0" fmla="*/ 9740 h 9740"/>
                <a:gd name="connsiteX1" fmla="*/ 9801 w 10403"/>
                <a:gd name="connsiteY1" fmla="*/ 49 h 9740"/>
                <a:gd name="connsiteX2" fmla="*/ 5449 w 10403"/>
                <a:gd name="connsiteY2" fmla="*/ 7750 h 9740"/>
                <a:gd name="connsiteX3" fmla="*/ 10267 w 10403"/>
                <a:gd name="connsiteY3" fmla="*/ 9740 h 9740"/>
                <a:gd name="connsiteX0" fmla="*/ 9564 w 9745"/>
                <a:gd name="connsiteY0" fmla="*/ 9865 h 9865"/>
                <a:gd name="connsiteX1" fmla="*/ 9421 w 9745"/>
                <a:gd name="connsiteY1" fmla="*/ 50 h 9865"/>
                <a:gd name="connsiteX2" fmla="*/ 5238 w 9745"/>
                <a:gd name="connsiteY2" fmla="*/ 7957 h 9865"/>
                <a:gd name="connsiteX3" fmla="*/ 9564 w 9745"/>
                <a:gd name="connsiteY3" fmla="*/ 9865 h 9865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9833 w 10120"/>
                <a:gd name="connsiteY0" fmla="*/ 10175 h 10175"/>
                <a:gd name="connsiteX1" fmla="*/ 9984 w 10120"/>
                <a:gd name="connsiteY1" fmla="*/ 51 h 10175"/>
                <a:gd name="connsiteX2" fmla="*/ 5691 w 10120"/>
                <a:gd name="connsiteY2" fmla="*/ 8066 h 10175"/>
                <a:gd name="connsiteX3" fmla="*/ 9833 w 10120"/>
                <a:gd name="connsiteY3" fmla="*/ 10175 h 10175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8463 w 18581"/>
                <a:gd name="connsiteY0" fmla="*/ 10150 h 10150"/>
                <a:gd name="connsiteX1" fmla="*/ 17855 w 18581"/>
                <a:gd name="connsiteY1" fmla="*/ 0 h 10150"/>
                <a:gd name="connsiteX2" fmla="*/ 12596 w 18581"/>
                <a:gd name="connsiteY2" fmla="*/ 7942 h 10150"/>
                <a:gd name="connsiteX3" fmla="*/ 18463 w 18581"/>
                <a:gd name="connsiteY3" fmla="*/ 10150 h 10150"/>
                <a:gd name="connsiteX0" fmla="*/ 608 w 726"/>
                <a:gd name="connsiteY0" fmla="*/ 10150 h 10150"/>
                <a:gd name="connsiteX1" fmla="*/ 0 w 726"/>
                <a:gd name="connsiteY1" fmla="*/ 0 h 10150"/>
                <a:gd name="connsiteX2" fmla="*/ 608 w 726"/>
                <a:gd name="connsiteY2" fmla="*/ 10150 h 10150"/>
                <a:gd name="connsiteX0" fmla="*/ 59658 w 61295"/>
                <a:gd name="connsiteY0" fmla="*/ 10000 h 10000"/>
                <a:gd name="connsiteX1" fmla="*/ 51283 w 61295"/>
                <a:gd name="connsiteY1" fmla="*/ 0 h 10000"/>
                <a:gd name="connsiteX2" fmla="*/ 59658 w 61295"/>
                <a:gd name="connsiteY2" fmla="*/ 10000 h 10000"/>
                <a:gd name="connsiteX0" fmla="*/ 59658 w 84651"/>
                <a:gd name="connsiteY0" fmla="*/ 10000 h 10000"/>
                <a:gd name="connsiteX1" fmla="*/ 51283 w 84651"/>
                <a:gd name="connsiteY1" fmla="*/ 0 h 10000"/>
                <a:gd name="connsiteX2" fmla="*/ 59658 w 84651"/>
                <a:gd name="connsiteY2" fmla="*/ 10000 h 10000"/>
                <a:gd name="connsiteX0" fmla="*/ 148647 w 173640"/>
                <a:gd name="connsiteY0" fmla="*/ 10000 h 10000"/>
                <a:gd name="connsiteX1" fmla="*/ 140272 w 173640"/>
                <a:gd name="connsiteY1" fmla="*/ 0 h 10000"/>
                <a:gd name="connsiteX2" fmla="*/ 148647 w 173640"/>
                <a:gd name="connsiteY2" fmla="*/ 10000 h 10000"/>
                <a:gd name="connsiteX0" fmla="*/ 148647 w 153064"/>
                <a:gd name="connsiteY0" fmla="*/ 10000 h 10000"/>
                <a:gd name="connsiteX1" fmla="*/ 140272 w 153064"/>
                <a:gd name="connsiteY1" fmla="*/ 0 h 10000"/>
                <a:gd name="connsiteX2" fmla="*/ 148647 w 153064"/>
                <a:gd name="connsiteY2" fmla="*/ 10000 h 10000"/>
                <a:gd name="connsiteX0" fmla="*/ 148647 w 148647"/>
                <a:gd name="connsiteY0" fmla="*/ 10000 h 10000"/>
                <a:gd name="connsiteX1" fmla="*/ 140272 w 148647"/>
                <a:gd name="connsiteY1" fmla="*/ 0 h 10000"/>
                <a:gd name="connsiteX2" fmla="*/ 148647 w 148647"/>
                <a:gd name="connsiteY2" fmla="*/ 10000 h 10000"/>
                <a:gd name="connsiteX0" fmla="*/ 154722 w 154722"/>
                <a:gd name="connsiteY0" fmla="*/ 10000 h 10000"/>
                <a:gd name="connsiteX1" fmla="*/ 146347 w 154722"/>
                <a:gd name="connsiteY1" fmla="*/ 0 h 10000"/>
                <a:gd name="connsiteX2" fmla="*/ 154722 w 154722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3231"/>
                <a:gd name="connsiteY0" fmla="*/ 10000 h 10000"/>
                <a:gd name="connsiteX1" fmla="*/ 144350 w 153231"/>
                <a:gd name="connsiteY1" fmla="*/ 0 h 10000"/>
                <a:gd name="connsiteX2" fmla="*/ 152725 w 153231"/>
                <a:gd name="connsiteY2" fmla="*/ 10000 h 10000"/>
                <a:gd name="connsiteX0" fmla="*/ 152725 w 153930"/>
                <a:gd name="connsiteY0" fmla="*/ 10000 h 10000"/>
                <a:gd name="connsiteX1" fmla="*/ 144350 w 153930"/>
                <a:gd name="connsiteY1" fmla="*/ 0 h 10000"/>
                <a:gd name="connsiteX2" fmla="*/ 152725 w 153930"/>
                <a:gd name="connsiteY2" fmla="*/ 10000 h 10000"/>
                <a:gd name="connsiteX0" fmla="*/ 152725 w 156746"/>
                <a:gd name="connsiteY0" fmla="*/ 10000 h 10000"/>
                <a:gd name="connsiteX1" fmla="*/ 144350 w 156746"/>
                <a:gd name="connsiteY1" fmla="*/ 0 h 10000"/>
                <a:gd name="connsiteX2" fmla="*/ 152725 w 156746"/>
                <a:gd name="connsiteY2" fmla="*/ 10000 h 10000"/>
                <a:gd name="connsiteX0" fmla="*/ 156368 w 160389"/>
                <a:gd name="connsiteY0" fmla="*/ 10000 h 10000"/>
                <a:gd name="connsiteX1" fmla="*/ 147993 w 160389"/>
                <a:gd name="connsiteY1" fmla="*/ 0 h 10000"/>
                <a:gd name="connsiteX2" fmla="*/ 156368 w 160389"/>
                <a:gd name="connsiteY2" fmla="*/ 10000 h 10000"/>
                <a:gd name="connsiteX0" fmla="*/ 159522 w 163543"/>
                <a:gd name="connsiteY0" fmla="*/ 10000 h 10000"/>
                <a:gd name="connsiteX1" fmla="*/ 151147 w 163543"/>
                <a:gd name="connsiteY1" fmla="*/ 0 h 10000"/>
                <a:gd name="connsiteX2" fmla="*/ 159522 w 163543"/>
                <a:gd name="connsiteY2" fmla="*/ 10000 h 10000"/>
                <a:gd name="connsiteX0" fmla="*/ 164492 w 168513"/>
                <a:gd name="connsiteY0" fmla="*/ 10000 h 10000"/>
                <a:gd name="connsiteX1" fmla="*/ 156117 w 168513"/>
                <a:gd name="connsiteY1" fmla="*/ 0 h 10000"/>
                <a:gd name="connsiteX2" fmla="*/ 164492 w 168513"/>
                <a:gd name="connsiteY2" fmla="*/ 10000 h 10000"/>
                <a:gd name="connsiteX0" fmla="*/ 157865 w 166869"/>
                <a:gd name="connsiteY0" fmla="*/ 10241 h 10241"/>
                <a:gd name="connsiteX1" fmla="*/ 161044 w 166869"/>
                <a:gd name="connsiteY1" fmla="*/ 0 h 10241"/>
                <a:gd name="connsiteX2" fmla="*/ 157865 w 166869"/>
                <a:gd name="connsiteY2" fmla="*/ 10241 h 102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6869" h="10241">
                  <a:moveTo>
                    <a:pt x="157865" y="10241"/>
                  </a:moveTo>
                  <a:cubicBezTo>
                    <a:pt x="166687" y="7400"/>
                    <a:pt x="171237" y="2927"/>
                    <a:pt x="161044" y="0"/>
                  </a:cubicBezTo>
                  <a:cubicBezTo>
                    <a:pt x="-90146" y="1558"/>
                    <a:pt x="-12963" y="7628"/>
                    <a:pt x="157865" y="10241"/>
                  </a:cubicBezTo>
                  <a:close/>
                </a:path>
              </a:pathLst>
            </a:custGeom>
            <a:gradFill flip="none" rotWithShape="1">
              <a:gsLst>
                <a:gs pos="20000">
                  <a:srgbClr val="DFDFDF"/>
                </a:gs>
                <a:gs pos="0">
                  <a:sysClr val="window" lastClr="FFFFFF">
                    <a:lumMod val="95000"/>
                  </a:sysClr>
                </a:gs>
                <a:gs pos="97000">
                  <a:sysClr val="window" lastClr="FFFFFF">
                    <a:lumMod val="65000"/>
                  </a:sysClr>
                </a:gs>
                <a:gs pos="69000">
                  <a:sysClr val="windowText" lastClr="000000">
                    <a:lumMod val="50000"/>
                    <a:lumOff val="50000"/>
                  </a:sysClr>
                </a:gs>
                <a:gs pos="84000">
                  <a:sysClr val="window" lastClr="FFFFFF">
                    <a:lumMod val="95000"/>
                  </a:sysClr>
                </a:gs>
              </a:gsLst>
              <a:lin ang="0" scaled="1"/>
              <a:tileRect/>
            </a:gradFill>
            <a:ln w="25400" cap="flat" cmpd="sng" algn="ctr">
              <a:noFill/>
              <a:prstDash val="solid"/>
            </a:ln>
            <a:effectLst>
              <a:outerShdw blurRad="177800" dist="38100" dir="720000" algn="l" rotWithShape="0">
                <a:prstClr val="black">
                  <a:alpha val="63000"/>
                </a:prstClr>
              </a:outerShdw>
            </a:effectLst>
          </p:spPr>
          <p:txBody>
            <a:bodyPr rtlCol="0"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9592047" y="70492"/>
              <a:ext cx="2617416" cy="744040"/>
            </a:xfrm>
            <a:prstGeom prst="rect">
              <a:avLst/>
            </a:prstGeom>
            <a:noFill/>
          </p:spPr>
          <p:txBody>
            <a:bodyPr wrap="square" lIns="432044" tIns="216022" rIns="432044" bIns="216022">
              <a:spAutoFit/>
            </a:bodyPr>
            <a:lstStyle>
              <a:defPPr>
                <a:defRPr lang="ar-EG"/>
              </a:defPPr>
              <a:lvl1pPr marL="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3" rtl="0">
                <a:spcBef>
                  <a:spcPct val="0"/>
                </a:spcBef>
                <a:defRPr/>
              </a:pPr>
              <a:r>
                <a:rPr lang="en-US" sz="2000" cap="small" dirty="0" smtClean="0">
                  <a:ln w="12700">
                    <a:noFill/>
                  </a:ln>
                  <a:solidFill>
                    <a:prstClr val="black"/>
                  </a:solidFill>
                  <a:latin typeface="Book Antiqua" pitchFamily="18" charset="0"/>
                  <a:cs typeface="Diwani Letter" pitchFamily="2" charset="-78"/>
                </a:rPr>
                <a:t>Results </a:t>
              </a:r>
              <a:endParaRPr lang="ar-EG" cap="small" dirty="0">
                <a:ln w="12700">
                  <a:noFill/>
                </a:ln>
                <a:solidFill>
                  <a:prstClr val="black"/>
                </a:solidFill>
                <a:latin typeface="Book Antiqua" pitchFamily="18" charset="0"/>
                <a:cs typeface="Diwani Letter" pitchFamily="2" charset="-78"/>
              </a:endParaRP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1054646" y="2060848"/>
            <a:ext cx="10585176" cy="2088231"/>
            <a:chOff x="8111283" y="5215504"/>
            <a:chExt cx="1827309" cy="1827309"/>
          </a:xfrm>
        </p:grpSpPr>
        <p:grpSp>
          <p:nvGrpSpPr>
            <p:cNvPr id="21" name="Group 20"/>
            <p:cNvGrpSpPr/>
            <p:nvPr/>
          </p:nvGrpSpPr>
          <p:grpSpPr>
            <a:xfrm rot="21155154">
              <a:off x="8111283" y="5215504"/>
              <a:ext cx="1827309" cy="1827309"/>
              <a:chOff x="-305747" y="2456837"/>
              <a:chExt cx="1223127" cy="1223127"/>
            </a:xfrm>
          </p:grpSpPr>
          <p:sp>
            <p:nvSpPr>
              <p:cNvPr id="23" name="Oval 22"/>
              <p:cNvSpPr/>
              <p:nvPr/>
            </p:nvSpPr>
            <p:spPr>
              <a:xfrm rot="11244846">
                <a:off x="-305747" y="2456837"/>
                <a:ext cx="1223127" cy="1223127"/>
              </a:xfrm>
              <a:prstGeom prst="round2DiagRect">
                <a:avLst/>
              </a:prstGeom>
              <a:noFill/>
              <a:ln w="28575" cap="flat" cmpd="sng" algn="ctr">
                <a:solidFill>
                  <a:srgbClr val="D8B25C"/>
                </a:solidFill>
                <a:prstDash val="sysDot"/>
              </a:ln>
              <a:effectLst>
                <a:outerShdw blurRad="149987" dist="250190" dir="8460000" algn="ctr">
                  <a:srgbClr val="000000">
                    <a:alpha val="28000"/>
                  </a:srgbClr>
                </a:outerShdw>
              </a:effectLst>
            </p:spPr>
            <p:txBody>
              <a:bodyPr rtlCol="1" anchor="ctr"/>
              <a:lstStyle/>
              <a:p>
                <a:pPr algn="ctr">
                  <a:defRPr/>
                </a:pPr>
                <a:endParaRPr lang="ar-EG" sz="2400" kern="0"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24" name="Oval 23"/>
              <p:cNvSpPr/>
              <p:nvPr/>
            </p:nvSpPr>
            <p:spPr>
              <a:xfrm>
                <a:off x="-272002" y="2505857"/>
                <a:ext cx="1153604" cy="1153604"/>
              </a:xfrm>
              <a:prstGeom prst="round2DiagRect">
                <a:avLst/>
              </a:prstGeom>
              <a:noFill/>
              <a:ln w="9525" cap="flat" cmpd="sng" algn="ctr">
                <a:noFill/>
                <a:prstDash val="solid"/>
              </a:ln>
              <a:effectLst/>
              <a:scene3d>
                <a:camera prst="orthographicFront">
                  <a:rot lat="0" lon="0" rev="0"/>
                </a:camera>
                <a:lightRig rig="contrasting" dir="t">
                  <a:rot lat="0" lon="0" rev="7800000"/>
                </a:lightRig>
              </a:scene3d>
              <a:sp3d>
                <a:bevelT w="139700" h="139700" prst="convex"/>
              </a:sp3d>
            </p:spPr>
            <p:txBody>
              <a:bodyPr rtlCol="1" anchor="ctr"/>
              <a:lstStyle/>
              <a:p>
                <a:pPr algn="ctr">
                  <a:defRPr/>
                </a:pPr>
                <a:endParaRPr lang="ar-EG" sz="2400" kern="0"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25" name="Oval 24"/>
              <p:cNvSpPr>
                <a:spLocks noChangeAspect="1"/>
              </p:cNvSpPr>
              <p:nvPr/>
            </p:nvSpPr>
            <p:spPr>
              <a:xfrm rot="444846">
                <a:off x="-248258" y="2505182"/>
                <a:ext cx="1096971" cy="1096972"/>
              </a:xfrm>
              <a:prstGeom prst="round2DiagRect">
                <a:avLst/>
              </a:prstGeom>
              <a:solidFill>
                <a:sysClr val="windowText" lastClr="000000">
                  <a:alpha val="43000"/>
                </a:sysClr>
              </a:solidFill>
              <a:ln w="12700" cap="flat" cmpd="sng" algn="ctr">
                <a:noFill/>
                <a:prstDash val="solid"/>
                <a:miter lim="800000"/>
              </a:ln>
              <a:effectLst>
                <a:outerShdw blurRad="149987" dist="250190" dir="8460000" algn="ctr">
                  <a:srgbClr val="000000">
                    <a:alpha val="28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contrasting" dir="t">
                  <a:rot lat="0" lon="0" rev="1500000"/>
                </a:lightRig>
              </a:scene3d>
              <a:sp3d prstMaterial="metal">
                <a:bevelT w="88900" h="88900"/>
              </a:sp3d>
            </p:spPr>
            <p:txBody>
              <a:bodyPr rtlCol="1" anchor="ctr"/>
              <a:lstStyle/>
              <a:p>
                <a:pPr algn="ctr">
                  <a:defRPr/>
                </a:pPr>
                <a:endParaRPr lang="ar-EG" kern="0">
                  <a:solidFill>
                    <a:prstClr val="white"/>
                  </a:solidFill>
                  <a:latin typeface="Calibri"/>
                </a:endParaRPr>
              </a:p>
            </p:txBody>
          </p:sp>
        </p:grpSp>
        <p:sp>
          <p:nvSpPr>
            <p:cNvPr id="22" name="Rectangle 21"/>
            <p:cNvSpPr/>
            <p:nvPr/>
          </p:nvSpPr>
          <p:spPr>
            <a:xfrm flipH="1">
              <a:off x="8293967" y="5554421"/>
              <a:ext cx="1459665" cy="223971"/>
            </a:xfrm>
            <a:prstGeom prst="round2DiagRect">
              <a:avLst/>
            </a:prstGeom>
            <a:noFill/>
          </p:spPr>
          <p:txBody>
            <a:bodyPr wrap="square" lIns="0" tIns="0" rIns="0" bIns="0">
              <a:spAutoFit/>
            </a:bodyPr>
            <a:lstStyle>
              <a:defPPr>
                <a:defRPr lang="ar-EG"/>
              </a:defPPr>
              <a:lvl1pPr marL="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rtl="0" fontAlgn="base">
                <a:lnSpc>
                  <a:spcPct val="110000"/>
                </a:lnSpc>
                <a:spcBef>
                  <a:spcPct val="0"/>
                </a:spcBef>
                <a:spcAft>
                  <a:spcPct val="0"/>
                </a:spcAft>
                <a:defRPr/>
              </a:pPr>
              <a:endParaRPr lang="en-GB" sz="2400" b="1" kern="0" dirty="0">
                <a:solidFill>
                  <a:prstClr val="white"/>
                </a:solidFill>
                <a:latin typeface="Book Antiqua" panose="02040602050305030304" pitchFamily="18" charset="0"/>
              </a:endParaRPr>
            </a:p>
          </p:txBody>
        </p:sp>
      </p:grpSp>
      <p:sp>
        <p:nvSpPr>
          <p:cNvPr id="12" name="Rectangle 21"/>
          <p:cNvSpPr/>
          <p:nvPr/>
        </p:nvSpPr>
        <p:spPr>
          <a:xfrm flipH="1">
            <a:off x="2062758" y="2420888"/>
            <a:ext cx="8424937" cy="1170391"/>
          </a:xfrm>
          <a:prstGeom prst="round2DiagRect">
            <a:avLst/>
          </a:prstGeom>
          <a:noFill/>
        </p:spPr>
        <p:txBody>
          <a:bodyPr wrap="square" lIns="0" tIns="0" rIns="0" bIns="0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rtl="0" fontAlgn="base">
              <a:lnSpc>
                <a:spcPct val="11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3200" b="1" kern="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So, the decline in </a:t>
            </a:r>
            <a:r>
              <a:rPr lang="en-GB" sz="3200" b="1" kern="0" dirty="0" smtClean="0">
                <a:solidFill>
                  <a:srgbClr val="FFCC66"/>
                </a:solidFill>
                <a:latin typeface="Book Antiqua" panose="02040602050305030304" pitchFamily="18" charset="0"/>
              </a:rPr>
              <a:t>Post-pacing</a:t>
            </a:r>
            <a:r>
              <a:rPr lang="en-GB" sz="3200" b="1" kern="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 </a:t>
            </a:r>
            <a:r>
              <a:rPr lang="en-GB" sz="3200" b="1" kern="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GLS preceded the decline in post-pacing LVEF at one week</a:t>
            </a:r>
            <a:endParaRPr lang="en-GB" sz="3200" b="1" kern="0" dirty="0">
              <a:solidFill>
                <a:srgbClr val="FFCC66"/>
              </a:solidFill>
              <a:latin typeface="Book Antiqua" panose="020406020503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671416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" presetClass="entr" presetSubtype="32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out)">
                                      <p:cBhvr>
                                        <p:cTn id="7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6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9" dur="500" tmFilter="0, 0; .2, .5; .8, .5; 1, 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10" dur="250" autoRev="1" fill="hold"/>
                                        <p:tgtEl>
                                          <p:spTgt spid="20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Ion">
  <a:themeElements>
    <a:clrScheme name="Ion">
      <a:dk1>
        <a:sysClr val="windowText" lastClr="000000"/>
      </a:dk1>
      <a:lt1>
        <a:sysClr val="window" lastClr="FFFFFF"/>
      </a:lt1>
      <a:dk2>
        <a:srgbClr val="1E5155"/>
      </a:dk2>
      <a:lt2>
        <a:srgbClr val="EBEBEB"/>
      </a:lt2>
      <a:accent1>
        <a:srgbClr val="B01513"/>
      </a:accent1>
      <a:accent2>
        <a:srgbClr val="EA6312"/>
      </a:accent2>
      <a:accent3>
        <a:srgbClr val="E6B729"/>
      </a:accent3>
      <a:accent4>
        <a:srgbClr val="6AAC90"/>
      </a:accent4>
      <a:accent5>
        <a:srgbClr val="54849A"/>
      </a:accent5>
      <a:accent6>
        <a:srgbClr val="9E5E9B"/>
      </a:accent6>
      <a:hlink>
        <a:srgbClr val="58C1BA"/>
      </a:hlink>
      <a:folHlink>
        <a:srgbClr val="9DFFCB"/>
      </a:folHlink>
    </a:clrScheme>
    <a:fontScheme name="Ion">
      <a:majorFont>
        <a:latin typeface="Century Gothic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7000"/>
                <a:hueMod val="88000"/>
                <a:satMod val="130000"/>
                <a:lumMod val="124000"/>
              </a:schemeClr>
            </a:gs>
            <a:gs pos="100000">
              <a:schemeClr val="phClr">
                <a:tint val="96000"/>
                <a:shade val="88000"/>
                <a:hueMod val="108000"/>
                <a:satMod val="164000"/>
                <a:lumMod val="7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9000"/>
                <a:hueMod val="108000"/>
                <a:satMod val="164000"/>
                <a:lumMod val="74000"/>
              </a:schemeClr>
              <a:schemeClr val="phClr">
                <a:tint val="96000"/>
                <a:hueMod val="88000"/>
                <a:satMod val="140000"/>
                <a:lumMod val="132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on" id="{B8441ADB-2E43-4AF7-B97A-BD870242C6A8}" vid="{292E63A9-BB86-4E3D-B92A-7223C6510D2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24</TotalTime>
  <Words>55</Words>
  <Application>Microsoft Office PowerPoint</Application>
  <PresentationFormat>Custom</PresentationFormat>
  <Paragraphs>22</Paragraphs>
  <Slides>8</Slides>
  <Notes>5</Notes>
  <HiddenSlides>0</HiddenSlides>
  <MMClips>3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8" baseType="lpstr">
      <vt:lpstr>AF_Unizah </vt:lpstr>
      <vt:lpstr>Arial</vt:lpstr>
      <vt:lpstr>Book Antiqua</vt:lpstr>
      <vt:lpstr>Calibri</vt:lpstr>
      <vt:lpstr>Cambria</vt:lpstr>
      <vt:lpstr>Century Gothic</vt:lpstr>
      <vt:lpstr>Clearly Gothic</vt:lpstr>
      <vt:lpstr>Diwani Letter</vt:lpstr>
      <vt:lpstr>Wingdings 3</vt:lpstr>
      <vt:lpstr>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a</dc:creator>
  <cp:lastModifiedBy>M</cp:lastModifiedBy>
  <cp:revision>6750</cp:revision>
  <dcterms:created xsi:type="dcterms:W3CDTF">2006-08-16T00:00:00Z</dcterms:created>
  <dcterms:modified xsi:type="dcterms:W3CDTF">2020-04-12T00:14:59Z</dcterms:modified>
</cp:coreProperties>
</file>